
<file path=[Content_Types].xml><?xml version="1.0" encoding="utf-8"?>
<Types xmlns="http://schemas.openxmlformats.org/package/2006/content-types">
  <Default Extension="jpeg" ContentType="image/jpeg"/>
  <Default Extension="jp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4"/>
  </p:notesMasterIdLst>
  <p:handoutMasterIdLst>
    <p:handoutMasterId r:id="rId5"/>
  </p:handoutMasterIdLst>
  <p:sldIdLst>
    <p:sldId id="262" r:id="rId2"/>
    <p:sldId id="261" r:id="rId3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10"/>
    <p:restoredTop sz="94656"/>
  </p:normalViewPr>
  <p:slideViewPr>
    <p:cSldViewPr snapToGrid="0" snapToObjects="1">
      <p:cViewPr varScale="1">
        <p:scale>
          <a:sx n="51" d="100"/>
          <a:sy n="51" d="100"/>
        </p:scale>
        <p:origin x="72" y="109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handoutMaster" Target="handoutMasters/handoutMaster1.xml"/><Relationship Id="rId4" Type="http://schemas.openxmlformats.org/officeDocument/2006/relationships/notesMaster" Target="notesMasters/notesMaster1.xml"/><Relationship Id="rId9" Type="http://schemas.openxmlformats.org/officeDocument/2006/relationships/tableStyles" Target="tableStyles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>
            <a:extLst>
              <a:ext uri="{FF2B5EF4-FFF2-40B4-BE49-F238E27FC236}">
                <a16:creationId xmlns:a16="http://schemas.microsoft.com/office/drawing/2014/main" id="{C81C82F6-551A-B844-9222-4E39E789523F}"/>
              </a:ext>
            </a:extLst>
          </p:cNvPr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r>
              <a:rPr lang="en-US"/>
              <a:t>Graper AL, Noyszewski AK, Anderson NO, Smith AG. Variability in ITS1 and ITS2 sequences of historic (herbaria) and extant (fresh) Phalaris species.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8CF5A2B3-412B-B546-A65F-F7BBEF82D240}"/>
              </a:ext>
            </a:extLst>
          </p:cNvPr>
          <p:cNvSpPr>
            <a:spLocks noGrp="1"/>
          </p:cNvSpPr>
          <p:nvPr>
            <p:ph type="dt" sz="quarter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2B6469B-9C61-2C4C-B59D-5949135315CC}" type="datetimeFigureOut">
              <a:rPr lang="en-US" smtClean="0"/>
              <a:t>5/23/2021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B87A9282-27D9-EC44-BBD7-9C0EAA012B43}"/>
              </a:ext>
            </a:extLst>
          </p:cNvPr>
          <p:cNvSpPr>
            <a:spLocks noGrp="1"/>
          </p:cNvSpPr>
          <p:nvPr>
            <p:ph type="ftr" sz="quarter" idx="2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1AE5E498-BEE6-A54C-9C46-60E8521F9250}"/>
              </a:ext>
            </a:extLst>
          </p:cNvPr>
          <p:cNvSpPr>
            <a:spLocks noGrp="1"/>
          </p:cNvSpPr>
          <p:nvPr>
            <p:ph type="sldNum" sz="quarter" idx="3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E6501652-9D6D-0C45-B44A-380C815DC1A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5103299"/>
      </p:ext>
    </p:extLst>
  </p:cSld>
  <p:clrMap bg1="lt1" tx1="dk1" bg2="lt2" tx2="dk2" accent1="accent1" accent2="accent2" accent3="accent3" accent4="accent4" accent5="accent5" accent6="accent6" hlink="hlink" folHlink="folHlink"/>
  <p:hf sldNum="0" ftr="0" dt="0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r>
              <a:rPr lang="en-US"/>
              <a:t>Graper AL, Noyszewski AK, Anderson NO, Smith AG. Variability in ITS1 and ITS2 sequences of historic (herbaria) and extant (fresh) Phalaris species.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5C2F9818-2B70-0C46-AB12-AA5126D488AA}" type="datetimeFigureOut">
              <a:rPr lang="en-US" smtClean="0"/>
              <a:t>5/23/2021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E3BCECAA-7E8F-AD4A-9493-E377DD99DD6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39444440"/>
      </p:ext>
    </p:extLst>
  </p:cSld>
  <p:clrMap bg1="lt1" tx1="dk1" bg2="lt2" tx2="dk2" accent1="accent1" accent2="accent2" accent3="accent3" accent4="accent4" accent5="accent5" accent6="accent6" hlink="hlink" folHlink="folHlink"/>
  <p:hf sldNum="0" ftr="0" dt="0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5" name="Header Placeholder 4">
            <a:extLst>
              <a:ext uri="{FF2B5EF4-FFF2-40B4-BE49-F238E27FC236}">
                <a16:creationId xmlns:a16="http://schemas.microsoft.com/office/drawing/2014/main" id="{5D9F0568-D04B-AF49-99EE-E14F34D9119B}"/>
              </a:ext>
            </a:extLst>
          </p:cNvPr>
          <p:cNvSpPr>
            <a:spLocks noGrp="1"/>
          </p:cNvSpPr>
          <p:nvPr>
            <p:ph type="hdr" sz="quarter"/>
          </p:nvPr>
        </p:nvSpPr>
        <p:spPr/>
        <p:txBody>
          <a:bodyPr/>
          <a:lstStyle/>
          <a:p>
            <a:r>
              <a:rPr lang="en-US"/>
              <a:t>Graper AL, Noyszewski AK, Anderson NO, Smith AG. Variability in ITS1 and ITS2 sequences of historic (herbaria) and extant (fresh) Phalaris species.</a:t>
            </a:r>
          </a:p>
        </p:txBody>
      </p:sp>
    </p:spTree>
    <p:extLst>
      <p:ext uri="{BB962C8B-B14F-4D97-AF65-F5344CB8AC3E}">
        <p14:creationId xmlns:p14="http://schemas.microsoft.com/office/powerpoint/2010/main" val="1985776983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D68DDC6-730D-7546-B280-D90A549A447C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8787175D-4D9D-4341-BAD7-7781BA80EAFA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ACC480C-82EC-7A4E-8383-EBC799C6483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DE249A-69F2-9C41-938D-0CE2E0D4F72C}" type="datetimeFigureOut">
              <a:rPr lang="en-US" smtClean="0"/>
              <a:t>5/23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20E1725-36BD-9D40-ABE9-3553D168B7D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809E5D5-8568-BC41-A2D3-512B2933E58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DE62E7-EC0C-8E43-8B75-77ACD8DE6AE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5071097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675A63B-1C2E-0345-8DEA-4E207E620A4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938CE0EB-B9D3-DC4B-B071-09898D054CA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6175086-50B8-D74E-9D51-40136171F61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DE249A-69F2-9C41-938D-0CE2E0D4F72C}" type="datetimeFigureOut">
              <a:rPr lang="en-US" smtClean="0"/>
              <a:t>5/23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7C96C40-7B05-EB4A-8438-44D1CFEC0A7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9D5DE46-4A89-2840-9BEE-75CB5BD7625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DE62E7-EC0C-8E43-8B75-77ACD8DE6AE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8074783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8C26D95C-E372-9F4D-AF11-DC4551BA92E3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CC1A3C70-D3DC-8C43-BA63-7BC799515CD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BD5E183-E1D0-D043-A796-7B149AF486D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DE249A-69F2-9C41-938D-0CE2E0D4F72C}" type="datetimeFigureOut">
              <a:rPr lang="en-US" smtClean="0"/>
              <a:t>5/23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F038A51-30BA-E647-ABB3-B2E14FB92F4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19BE795-40E4-3446-A723-9831C1EA0B8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DE62E7-EC0C-8E43-8B75-77ACD8DE6AE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4226419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5C1BCCF-F056-6440-8AB3-2792F76DFB1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3488B2A-7F96-6545-88C3-304BD2304078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87531A8-E048-114F-AE8B-807EA0F252D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DE249A-69F2-9C41-938D-0CE2E0D4F72C}" type="datetimeFigureOut">
              <a:rPr lang="en-US" smtClean="0"/>
              <a:t>5/23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432AD7A-352D-4046-B65A-ABEEB7E67CA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A6FBB83-A722-FF4B-A70D-25226F80283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DE62E7-EC0C-8E43-8B75-77ACD8DE6AE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4815058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9B3607A-8C49-E64A-9A18-52756F8B80A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7593E900-8276-9F48-B344-B0D5B4CDB79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320E68D-8C7B-9146-AC63-C0C1F2F701A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DE249A-69F2-9C41-938D-0CE2E0D4F72C}" type="datetimeFigureOut">
              <a:rPr lang="en-US" smtClean="0"/>
              <a:t>5/23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A09D0BF-243C-374F-97EC-0B13EB23421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F737549-843A-E44D-9177-5BC0CF3D1E0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DE62E7-EC0C-8E43-8B75-77ACD8DE6AE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9845372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39C146B-30BF-3648-97FE-854996ECE9D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B01FB91-AD0F-7E41-A8A5-4F4542F91075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E41DAD17-0129-554B-85B4-6699EF2E0EA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B60F6F22-B7A3-1442-8537-62E7FB6AE85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DE249A-69F2-9C41-938D-0CE2E0D4F72C}" type="datetimeFigureOut">
              <a:rPr lang="en-US" smtClean="0"/>
              <a:t>5/23/20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EB459260-130B-204B-B2C2-4F09E5AED82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B23C2FDE-B930-6B42-BF0B-A7837CB75C5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DE62E7-EC0C-8E43-8B75-77ACD8DE6AE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0716964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C99D1D6-D07A-A840-ACB1-3DD4703F757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C2D042E7-96D9-0A45-A1F1-2B968767074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EB70ACBF-6B4D-F34E-A237-3B45B0979CB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38ADCECC-523D-9D47-861E-53FB9AB3B077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685BD621-0E42-224E-B36E-EC3E783A90B6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4370F2A0-63A6-DD47-B051-4C69B3109B8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DE249A-69F2-9C41-938D-0CE2E0D4F72C}" type="datetimeFigureOut">
              <a:rPr lang="en-US" smtClean="0"/>
              <a:t>5/23/2021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22BECC4C-A5E9-D940-A78A-A5C747E6DE3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E8EC04AF-19F0-6F46-88BB-39B2ED1EB0F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DE62E7-EC0C-8E43-8B75-77ACD8DE6AE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377046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2F7E2E1-B0DD-AE4E-BFB8-27E2175AB81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8306C024-A934-AD46-884A-409FBD92AF4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DE249A-69F2-9C41-938D-0CE2E0D4F72C}" type="datetimeFigureOut">
              <a:rPr lang="en-US" smtClean="0"/>
              <a:t>5/23/2021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E1216BB9-0497-084E-B9C8-1EC37CBA520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94DF1E76-FE8D-2C4E-942F-78C58A0986F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DE62E7-EC0C-8E43-8B75-77ACD8DE6AE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7192766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3C297BDC-EC92-A441-8FFA-471CC2B2B09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DE249A-69F2-9C41-938D-0CE2E0D4F72C}" type="datetimeFigureOut">
              <a:rPr lang="en-US" smtClean="0"/>
              <a:t>5/23/2021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C0CD82CD-7408-DF40-8B77-325015E3EDD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6F196966-75AA-8F4F-81E9-01BCC5CB552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DE62E7-EC0C-8E43-8B75-77ACD8DE6AE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1722561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2DACD6B-7D33-6F44-88B7-8B5135ED971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0E264E2-FFE8-B34F-B493-3C14F4F261B4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2E7460E2-5AE7-CE4C-A618-9FC1A1E4370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CAEF578A-9CFD-D446-A267-D236E62675F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DE249A-69F2-9C41-938D-0CE2E0D4F72C}" type="datetimeFigureOut">
              <a:rPr lang="en-US" smtClean="0"/>
              <a:t>5/23/20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B9367340-5530-BB4C-800B-06F5C00A3C1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16B56937-C25B-BB45-B279-62877E6E76C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DE62E7-EC0C-8E43-8B75-77ACD8DE6AE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3777710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4646214-3B67-CA47-956B-C495CE43FF2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89770AF9-FE48-CC41-854E-3D5D451999F7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E6157BDC-4F70-0642-88B6-F7ECCA4AA1F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09E9B107-8B0F-6546-A733-B657A2D2A4D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DE249A-69F2-9C41-938D-0CE2E0D4F72C}" type="datetimeFigureOut">
              <a:rPr lang="en-US" smtClean="0"/>
              <a:t>5/23/20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C2B039B8-BDAA-9C4B-9DDD-3EC40E3104B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A50361BD-4CBA-5C45-8A1A-F92A42A2BB7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DE62E7-EC0C-8E43-8B75-77ACD8DE6AE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1426917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8AC77453-FA06-E043-8859-A0CA153A2AF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64ED0A1B-49D2-0F41-994F-B618B65E1CF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E59828D-62AE-8E41-BFE8-F19C78790BC5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BDE249A-69F2-9C41-938D-0CE2E0D4F72C}" type="datetimeFigureOut">
              <a:rPr lang="en-US" smtClean="0"/>
              <a:t>5/23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C2B6DE6-09C6-C84B-8DE0-E3B616CD226B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F71C416-BE37-8247-8798-34B5EA79D60D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DDE62E7-EC0C-8E43-8B75-77ACD8DE6AE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2049339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6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jp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3.png"/><Relationship Id="rId4" Type="http://schemas.openxmlformats.org/officeDocument/2006/relationships/image" Target="../media/image2.jp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>
            <a:extLst>
              <a:ext uri="{FF2B5EF4-FFF2-40B4-BE49-F238E27FC236}">
                <a16:creationId xmlns:a16="http://schemas.microsoft.com/office/drawing/2014/main" id="{D1297051-70AF-A948-950F-77E90FB58EB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0"/>
            <a:ext cx="10515600" cy="1325563"/>
          </a:xfrm>
        </p:spPr>
        <p:txBody>
          <a:bodyPr>
            <a:normAutofit/>
          </a:bodyPr>
          <a:lstStyle/>
          <a:p>
            <a:r>
              <a:rPr lang="en-US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Variability in ITS1 and ITS2 sequences of historic (herbaria) and extant (fresh) Phalaris species (Graper, Noyszewski, Anderson, Smith) Supplementary </a:t>
            </a:r>
            <a:r>
              <a:rPr lang="en-US" sz="2000">
                <a:latin typeface="Times New Roman" panose="02020603050405020304" pitchFamily="18" charset="0"/>
                <a:cs typeface="Times New Roman" panose="02020603050405020304" pitchFamily="18" charset="0"/>
              </a:rPr>
              <a:t>Figure 3</a:t>
            </a:r>
            <a:endParaRPr lang="en-US" sz="2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52924009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39" name="Group 138"/>
          <p:cNvGrpSpPr/>
          <p:nvPr/>
        </p:nvGrpSpPr>
        <p:grpSpPr>
          <a:xfrm>
            <a:off x="2280824" y="285594"/>
            <a:ext cx="7971001" cy="6080819"/>
            <a:chOff x="2268020" y="285594"/>
            <a:chExt cx="7971001" cy="6080819"/>
          </a:xfrm>
        </p:grpSpPr>
        <p:pic>
          <p:nvPicPr>
            <p:cNvPr id="4" name="Picture 3"/>
            <p:cNvPicPr>
              <a:picLocks noChangeAspect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r="11955"/>
            <a:stretch/>
          </p:blipFill>
          <p:spPr>
            <a:xfrm>
              <a:off x="2268020" y="285594"/>
              <a:ext cx="7018116" cy="4959929"/>
            </a:xfrm>
            <a:prstGeom prst="rect">
              <a:avLst/>
            </a:prstGeom>
          </p:spPr>
        </p:pic>
        <p:pic>
          <p:nvPicPr>
            <p:cNvPr id="5" name="Picture 4"/>
            <p:cNvPicPr>
              <a:picLocks noChangeAspect="1"/>
            </p:cNvPicPr>
            <p:nvPr/>
          </p:nvPicPr>
          <p:blipFill rotWithShape="1"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76480"/>
            <a:stretch/>
          </p:blipFill>
          <p:spPr>
            <a:xfrm>
              <a:off x="2268261" y="5199865"/>
              <a:ext cx="7970760" cy="1166548"/>
            </a:xfrm>
            <a:prstGeom prst="rect">
              <a:avLst/>
            </a:prstGeom>
          </p:spPr>
        </p:pic>
      </p:grpSp>
      <p:sp>
        <p:nvSpPr>
          <p:cNvPr id="8" name="Rectangle 7"/>
          <p:cNvSpPr/>
          <p:nvPr/>
        </p:nvSpPr>
        <p:spPr>
          <a:xfrm>
            <a:off x="2721668" y="64331"/>
            <a:ext cx="934595" cy="6671682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9" name="Rectangle 8"/>
          <p:cNvSpPr/>
          <p:nvPr/>
        </p:nvSpPr>
        <p:spPr>
          <a:xfrm>
            <a:off x="2147991" y="275465"/>
            <a:ext cx="8859730" cy="156347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94" name="TextBox 93"/>
          <p:cNvSpPr txBox="1"/>
          <p:nvPr/>
        </p:nvSpPr>
        <p:spPr>
          <a:xfrm>
            <a:off x="2722288" y="429613"/>
            <a:ext cx="761510" cy="69250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r>
              <a:rPr lang="en-US" sz="450" i="1" dirty="0"/>
              <a:t>P. </a:t>
            </a:r>
            <a:r>
              <a:rPr lang="en-US" sz="450" i="1" dirty="0" err="1"/>
              <a:t>truncata</a:t>
            </a:r>
            <a:r>
              <a:rPr lang="en-US" sz="450" i="1" dirty="0"/>
              <a:t> </a:t>
            </a:r>
            <a:r>
              <a:rPr lang="en-US" sz="450" dirty="0"/>
              <a:t>(MN811199.1) </a:t>
            </a:r>
          </a:p>
        </p:txBody>
      </p:sp>
      <p:pic>
        <p:nvPicPr>
          <p:cNvPr id="104" name="Picture 103"/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11955" b="98514"/>
          <a:stretch/>
        </p:blipFill>
        <p:spPr>
          <a:xfrm>
            <a:off x="2274569" y="294328"/>
            <a:ext cx="7018116" cy="73691"/>
          </a:xfrm>
          <a:prstGeom prst="rect">
            <a:avLst/>
          </a:prstGeom>
        </p:spPr>
      </p:pic>
      <p:pic>
        <p:nvPicPr>
          <p:cNvPr id="155" name="Picture 154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3656263" y="366386"/>
            <a:ext cx="5636422" cy="72932"/>
          </a:xfrm>
          <a:prstGeom prst="rect">
            <a:avLst/>
          </a:prstGeom>
        </p:spPr>
      </p:pic>
      <p:sp>
        <p:nvSpPr>
          <p:cNvPr id="165" name="TextBox 164"/>
          <p:cNvSpPr txBox="1"/>
          <p:nvPr/>
        </p:nvSpPr>
        <p:spPr>
          <a:xfrm>
            <a:off x="6876711" y="437986"/>
            <a:ext cx="95388" cy="107722"/>
          </a:xfrm>
          <a:prstGeom prst="rect">
            <a:avLst/>
          </a:prstGeom>
          <a:solidFill>
            <a:schemeClr val="bg1"/>
          </a:solidFill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US" sz="700" dirty="0"/>
              <a:t>T3</a:t>
            </a:r>
            <a:endParaRPr lang="en-US" dirty="0"/>
          </a:p>
        </p:txBody>
      </p:sp>
      <p:cxnSp>
        <p:nvCxnSpPr>
          <p:cNvPr id="273" name="Straight Connector 272"/>
          <p:cNvCxnSpPr/>
          <p:nvPr/>
        </p:nvCxnSpPr>
        <p:spPr>
          <a:xfrm flipV="1">
            <a:off x="1666460" y="429613"/>
            <a:ext cx="7680960" cy="0"/>
          </a:xfrm>
          <a:prstGeom prst="line">
            <a:avLst/>
          </a:prstGeom>
          <a:ln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2" name="Group 1">
            <a:extLst>
              <a:ext uri="{FF2B5EF4-FFF2-40B4-BE49-F238E27FC236}">
                <a16:creationId xmlns:a16="http://schemas.microsoft.com/office/drawing/2014/main" id="{6B313426-8470-4355-9F1B-A95C3D225B1A}"/>
              </a:ext>
            </a:extLst>
          </p:cNvPr>
          <p:cNvGrpSpPr/>
          <p:nvPr/>
        </p:nvGrpSpPr>
        <p:grpSpPr>
          <a:xfrm>
            <a:off x="1547190" y="438799"/>
            <a:ext cx="7856120" cy="5937962"/>
            <a:chOff x="1558913" y="438799"/>
            <a:chExt cx="7856120" cy="5937962"/>
          </a:xfrm>
        </p:grpSpPr>
        <p:cxnSp>
          <p:nvCxnSpPr>
            <p:cNvPr id="11" name="Straight Connector 10"/>
            <p:cNvCxnSpPr/>
            <p:nvPr/>
          </p:nvCxnSpPr>
          <p:spPr>
            <a:xfrm flipV="1">
              <a:off x="1663205" y="5909577"/>
              <a:ext cx="7680960" cy="0"/>
            </a:xfrm>
            <a:prstGeom prst="line">
              <a:avLst/>
            </a:prstGeom>
            <a:ln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2" name="TextBox 11"/>
            <p:cNvSpPr txBox="1"/>
            <p:nvPr/>
          </p:nvSpPr>
          <p:spPr>
            <a:xfrm>
              <a:off x="1621722" y="558093"/>
              <a:ext cx="1026171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600" i="1" dirty="0"/>
                <a:t>P.  truncata</a:t>
              </a:r>
            </a:p>
          </p:txBody>
        </p:sp>
        <p:sp>
          <p:nvSpPr>
            <p:cNvPr id="13" name="TextBox 12"/>
            <p:cNvSpPr txBox="1"/>
            <p:nvPr/>
          </p:nvSpPr>
          <p:spPr>
            <a:xfrm>
              <a:off x="1595426" y="1183344"/>
              <a:ext cx="223438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600" i="1" dirty="0"/>
                <a:t>P. brachystachys/</a:t>
              </a:r>
            </a:p>
            <a:p>
              <a:r>
                <a:rPr lang="en-US" sz="600" i="1" dirty="0"/>
                <a:t>P. canariensis</a:t>
              </a:r>
            </a:p>
          </p:txBody>
        </p:sp>
        <p:sp>
          <p:nvSpPr>
            <p:cNvPr id="14" name="TextBox 13"/>
            <p:cNvSpPr txBox="1"/>
            <p:nvPr/>
          </p:nvSpPr>
          <p:spPr>
            <a:xfrm>
              <a:off x="1558913" y="4375408"/>
              <a:ext cx="2234380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00" i="1" dirty="0"/>
                <a:t>P.  arundinacea</a:t>
              </a:r>
            </a:p>
          </p:txBody>
        </p:sp>
        <p:sp>
          <p:nvSpPr>
            <p:cNvPr id="15" name="TextBox 14"/>
            <p:cNvSpPr txBox="1"/>
            <p:nvPr/>
          </p:nvSpPr>
          <p:spPr>
            <a:xfrm>
              <a:off x="1595426" y="1935295"/>
              <a:ext cx="809905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00" i="1" dirty="0"/>
                <a:t>P.  aquatica</a:t>
              </a:r>
            </a:p>
          </p:txBody>
        </p:sp>
        <p:sp>
          <p:nvSpPr>
            <p:cNvPr id="16" name="TextBox 15"/>
            <p:cNvSpPr txBox="1"/>
            <p:nvPr/>
          </p:nvSpPr>
          <p:spPr>
            <a:xfrm>
              <a:off x="1568220" y="3433949"/>
              <a:ext cx="2234380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00" i="1" dirty="0"/>
                <a:t>P.  paradoxa</a:t>
              </a:r>
            </a:p>
          </p:txBody>
        </p:sp>
        <p:sp>
          <p:nvSpPr>
            <p:cNvPr id="17" name="TextBox 16"/>
            <p:cNvSpPr txBox="1"/>
            <p:nvPr/>
          </p:nvSpPr>
          <p:spPr>
            <a:xfrm>
              <a:off x="1562991" y="2888824"/>
              <a:ext cx="2244837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00" i="1" dirty="0"/>
                <a:t>P.  minor</a:t>
              </a:r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1568220" y="2454907"/>
              <a:ext cx="2234380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00" i="1" dirty="0"/>
                <a:t>P.  coerulescens</a:t>
              </a:r>
            </a:p>
          </p:txBody>
        </p:sp>
        <p:sp>
          <p:nvSpPr>
            <p:cNvPr id="19" name="TextBox 18"/>
            <p:cNvSpPr txBox="1"/>
            <p:nvPr/>
          </p:nvSpPr>
          <p:spPr>
            <a:xfrm>
              <a:off x="1581228" y="5060825"/>
              <a:ext cx="2234380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00" i="1" dirty="0"/>
                <a:t>P.  californica</a:t>
              </a:r>
            </a:p>
          </p:txBody>
        </p:sp>
        <p:sp>
          <p:nvSpPr>
            <p:cNvPr id="20" name="TextBox 19"/>
            <p:cNvSpPr txBox="1"/>
            <p:nvPr/>
          </p:nvSpPr>
          <p:spPr>
            <a:xfrm>
              <a:off x="1581228" y="5413663"/>
              <a:ext cx="2234380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00" i="1" dirty="0"/>
                <a:t>P.  caroliniana</a:t>
              </a:r>
            </a:p>
          </p:txBody>
        </p:sp>
        <p:sp>
          <p:nvSpPr>
            <p:cNvPr id="21" name="TextBox 20"/>
            <p:cNvSpPr txBox="1"/>
            <p:nvPr/>
          </p:nvSpPr>
          <p:spPr>
            <a:xfrm>
              <a:off x="1601378" y="5926430"/>
              <a:ext cx="2234380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00" i="1" dirty="0"/>
                <a:t>P.  lemmonii</a:t>
              </a:r>
            </a:p>
          </p:txBody>
        </p:sp>
        <p:sp>
          <p:nvSpPr>
            <p:cNvPr id="22" name="TextBox 21"/>
            <p:cNvSpPr txBox="1"/>
            <p:nvPr/>
          </p:nvSpPr>
          <p:spPr>
            <a:xfrm>
              <a:off x="1601378" y="6154803"/>
              <a:ext cx="2234380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00" i="1" dirty="0"/>
                <a:t>P.  angusta</a:t>
              </a:r>
            </a:p>
          </p:txBody>
        </p:sp>
        <p:sp>
          <p:nvSpPr>
            <p:cNvPr id="24" name="TextBox 23"/>
            <p:cNvSpPr txBox="1"/>
            <p:nvPr/>
          </p:nvSpPr>
          <p:spPr>
            <a:xfrm>
              <a:off x="2723539" y="3908153"/>
              <a:ext cx="769974" cy="69250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r>
                <a:rPr lang="en-US" sz="450" i="1" dirty="0"/>
                <a:t>P. arundinacea </a:t>
              </a:r>
              <a:r>
                <a:rPr lang="en-US" sz="450" dirty="0"/>
                <a:t>(HF564628.1) </a:t>
              </a:r>
            </a:p>
          </p:txBody>
        </p:sp>
        <p:sp>
          <p:nvSpPr>
            <p:cNvPr id="25" name="TextBox 24"/>
            <p:cNvSpPr txBox="1"/>
            <p:nvPr/>
          </p:nvSpPr>
          <p:spPr>
            <a:xfrm>
              <a:off x="2717961" y="4477877"/>
              <a:ext cx="734137" cy="69250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r>
                <a:rPr lang="en-US" sz="450" i="1" dirty="0"/>
                <a:t>P. arundinacea </a:t>
              </a:r>
              <a:r>
                <a:rPr lang="en-US" sz="450" dirty="0"/>
                <a:t>(JF951077.1) </a:t>
              </a:r>
            </a:p>
          </p:txBody>
        </p:sp>
        <p:sp>
          <p:nvSpPr>
            <p:cNvPr id="26" name="TextBox 25"/>
            <p:cNvSpPr txBox="1"/>
            <p:nvPr/>
          </p:nvSpPr>
          <p:spPr>
            <a:xfrm>
              <a:off x="2717961" y="4360775"/>
              <a:ext cx="734137" cy="69250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r>
                <a:rPr lang="en-US" sz="450" i="1" dirty="0"/>
                <a:t>P. arundinacea </a:t>
              </a:r>
              <a:r>
                <a:rPr lang="en-US" sz="450" dirty="0"/>
                <a:t>(KF713251.1) </a:t>
              </a:r>
            </a:p>
          </p:txBody>
        </p:sp>
        <p:sp>
          <p:nvSpPr>
            <p:cNvPr id="27" name="TextBox 26"/>
            <p:cNvSpPr txBox="1"/>
            <p:nvPr/>
          </p:nvSpPr>
          <p:spPr>
            <a:xfrm>
              <a:off x="2722544" y="4251912"/>
              <a:ext cx="774139" cy="69250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r>
                <a:rPr lang="en-US" sz="450" i="1" dirty="0"/>
                <a:t>P. arundinacea </a:t>
              </a:r>
              <a:r>
                <a:rPr lang="en-US" sz="450" dirty="0"/>
                <a:t>(KF713253.1) </a:t>
              </a:r>
            </a:p>
          </p:txBody>
        </p:sp>
        <p:sp>
          <p:nvSpPr>
            <p:cNvPr id="28" name="TextBox 27"/>
            <p:cNvSpPr txBox="1"/>
            <p:nvPr/>
          </p:nvSpPr>
          <p:spPr>
            <a:xfrm>
              <a:off x="2714827" y="4987699"/>
              <a:ext cx="778831" cy="69250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r>
                <a:rPr lang="en-US" sz="450" i="1" dirty="0"/>
                <a:t>P. arundinacea </a:t>
              </a:r>
              <a:r>
                <a:rPr lang="en-US" sz="450" dirty="0"/>
                <a:t>(KF713255.1) </a:t>
              </a:r>
            </a:p>
          </p:txBody>
        </p:sp>
        <p:sp>
          <p:nvSpPr>
            <p:cNvPr id="29" name="TextBox 28"/>
            <p:cNvSpPr txBox="1"/>
            <p:nvPr/>
          </p:nvSpPr>
          <p:spPr>
            <a:xfrm>
              <a:off x="2717120" y="4189797"/>
              <a:ext cx="731784" cy="69250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r>
                <a:rPr lang="en-US" sz="450" i="1" dirty="0"/>
                <a:t>P. arundinacea </a:t>
              </a:r>
              <a:r>
                <a:rPr lang="en-US" sz="450" dirty="0"/>
                <a:t>(KF713254.1) </a:t>
              </a:r>
            </a:p>
          </p:txBody>
        </p:sp>
        <p:sp>
          <p:nvSpPr>
            <p:cNvPr id="30" name="TextBox 29"/>
            <p:cNvSpPr txBox="1"/>
            <p:nvPr/>
          </p:nvSpPr>
          <p:spPr>
            <a:xfrm>
              <a:off x="2717961" y="4536511"/>
              <a:ext cx="774747" cy="69250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r>
                <a:rPr lang="en-US" sz="450" i="1" dirty="0"/>
                <a:t>P. arundinacea </a:t>
              </a:r>
              <a:r>
                <a:rPr lang="en-US" sz="450" dirty="0"/>
                <a:t>(KF713257.1) </a:t>
              </a:r>
            </a:p>
          </p:txBody>
        </p:sp>
        <p:sp>
          <p:nvSpPr>
            <p:cNvPr id="31" name="TextBox 30"/>
            <p:cNvSpPr txBox="1"/>
            <p:nvPr/>
          </p:nvSpPr>
          <p:spPr>
            <a:xfrm>
              <a:off x="2718582" y="4422558"/>
              <a:ext cx="808073" cy="69250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r>
                <a:rPr lang="en-US" sz="450" i="1" dirty="0"/>
                <a:t>P. arundinacea </a:t>
              </a:r>
              <a:r>
                <a:rPr lang="en-US" sz="450" dirty="0"/>
                <a:t>(KF753779.1) </a:t>
              </a:r>
            </a:p>
          </p:txBody>
        </p:sp>
        <p:sp>
          <p:nvSpPr>
            <p:cNvPr id="32" name="TextBox 31"/>
            <p:cNvSpPr txBox="1"/>
            <p:nvPr/>
          </p:nvSpPr>
          <p:spPr>
            <a:xfrm>
              <a:off x="2719983" y="4130302"/>
              <a:ext cx="807477" cy="69250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r>
                <a:rPr lang="en-US" sz="450" i="1" dirty="0"/>
                <a:t>P. arundinacea </a:t>
              </a:r>
              <a:r>
                <a:rPr lang="en-US" sz="450" dirty="0"/>
                <a:t>(KP711073.1) </a:t>
              </a:r>
            </a:p>
          </p:txBody>
        </p:sp>
        <p:sp>
          <p:nvSpPr>
            <p:cNvPr id="33" name="TextBox 32"/>
            <p:cNvSpPr txBox="1"/>
            <p:nvPr/>
          </p:nvSpPr>
          <p:spPr>
            <a:xfrm>
              <a:off x="2714090" y="4928935"/>
              <a:ext cx="845487" cy="69250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r>
                <a:rPr lang="en-US" sz="450" i="1" dirty="0"/>
                <a:t>P. arundinacea </a:t>
              </a:r>
              <a:r>
                <a:rPr lang="en-US" sz="450" dirty="0"/>
                <a:t>(KU883517.1) </a:t>
              </a:r>
            </a:p>
          </p:txBody>
        </p:sp>
        <p:sp>
          <p:nvSpPr>
            <p:cNvPr id="34" name="TextBox 33"/>
            <p:cNvSpPr txBox="1"/>
            <p:nvPr/>
          </p:nvSpPr>
          <p:spPr>
            <a:xfrm>
              <a:off x="2718569" y="5615580"/>
              <a:ext cx="688515" cy="68926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r>
                <a:rPr lang="en-US" sz="450" i="1" dirty="0">
                  <a:solidFill>
                    <a:srgbClr val="FF0000"/>
                  </a:solidFill>
                </a:rPr>
                <a:t>P. caroliniana </a:t>
              </a:r>
              <a:r>
                <a:rPr lang="en-US" sz="450" dirty="0">
                  <a:solidFill>
                    <a:srgbClr val="FF0000"/>
                  </a:solidFill>
                </a:rPr>
                <a:t>(JF951065.1) </a:t>
              </a:r>
            </a:p>
          </p:txBody>
        </p:sp>
        <p:sp>
          <p:nvSpPr>
            <p:cNvPr id="35" name="TextBox 34"/>
            <p:cNvSpPr txBox="1"/>
            <p:nvPr/>
          </p:nvSpPr>
          <p:spPr>
            <a:xfrm>
              <a:off x="2721555" y="5555485"/>
              <a:ext cx="729364" cy="69250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r>
                <a:rPr lang="en-US" sz="450" i="1" dirty="0"/>
                <a:t>P. caroliniana </a:t>
              </a:r>
              <a:r>
                <a:rPr lang="en-US" sz="450" dirty="0"/>
                <a:t>(JF951079.1) </a:t>
              </a:r>
            </a:p>
          </p:txBody>
        </p:sp>
        <p:sp>
          <p:nvSpPr>
            <p:cNvPr id="36" name="TextBox 35"/>
            <p:cNvSpPr txBox="1"/>
            <p:nvPr/>
          </p:nvSpPr>
          <p:spPr>
            <a:xfrm>
              <a:off x="2715824" y="5501613"/>
              <a:ext cx="633495" cy="69250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r>
                <a:rPr lang="en-US" sz="450" i="1" dirty="0"/>
                <a:t>P. caroliniana </a:t>
              </a:r>
              <a:r>
                <a:rPr lang="en-US" sz="450" dirty="0"/>
                <a:t>(JF951080.1) </a:t>
              </a:r>
            </a:p>
          </p:txBody>
        </p:sp>
        <p:sp>
          <p:nvSpPr>
            <p:cNvPr id="37" name="TextBox 36"/>
            <p:cNvSpPr txBox="1"/>
            <p:nvPr/>
          </p:nvSpPr>
          <p:spPr>
            <a:xfrm>
              <a:off x="2716259" y="6016575"/>
              <a:ext cx="687646" cy="71293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r>
                <a:rPr lang="en-US" sz="450" i="1" dirty="0"/>
                <a:t>P. lemmonii </a:t>
              </a:r>
              <a:r>
                <a:rPr lang="en-US" sz="450" dirty="0"/>
                <a:t>(JF951082.1) </a:t>
              </a:r>
            </a:p>
          </p:txBody>
        </p:sp>
        <p:sp>
          <p:nvSpPr>
            <p:cNvPr id="38" name="TextBox 37"/>
            <p:cNvSpPr txBox="1"/>
            <p:nvPr/>
          </p:nvSpPr>
          <p:spPr>
            <a:xfrm>
              <a:off x="2716948" y="5106796"/>
              <a:ext cx="729364" cy="69250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r>
                <a:rPr lang="en-US" sz="450" i="1" dirty="0"/>
                <a:t>P. californica </a:t>
              </a:r>
              <a:r>
                <a:rPr lang="en-US" sz="450" dirty="0"/>
                <a:t>(JF951064.1) </a:t>
              </a:r>
            </a:p>
          </p:txBody>
        </p:sp>
        <p:sp>
          <p:nvSpPr>
            <p:cNvPr id="39" name="TextBox 38"/>
            <p:cNvSpPr txBox="1"/>
            <p:nvPr/>
          </p:nvSpPr>
          <p:spPr>
            <a:xfrm>
              <a:off x="2720997" y="5044641"/>
              <a:ext cx="769973" cy="69250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r>
                <a:rPr lang="en-US" sz="450" i="1" dirty="0"/>
                <a:t>P. californica </a:t>
              </a:r>
              <a:r>
                <a:rPr lang="en-US" sz="450" dirty="0"/>
                <a:t>(JF951078.1) </a:t>
              </a:r>
            </a:p>
          </p:txBody>
        </p:sp>
        <p:sp>
          <p:nvSpPr>
            <p:cNvPr id="40" name="TextBox 39"/>
            <p:cNvSpPr txBox="1"/>
            <p:nvPr/>
          </p:nvSpPr>
          <p:spPr>
            <a:xfrm>
              <a:off x="2720652" y="5212112"/>
              <a:ext cx="688516" cy="69250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r>
                <a:rPr lang="en-US" sz="450" i="1" dirty="0"/>
                <a:t>P. californica </a:t>
              </a:r>
              <a:r>
                <a:rPr lang="en-US" sz="450" dirty="0"/>
                <a:t>(KF753781.1) </a:t>
              </a:r>
            </a:p>
          </p:txBody>
        </p:sp>
        <p:sp>
          <p:nvSpPr>
            <p:cNvPr id="41" name="TextBox 40"/>
            <p:cNvSpPr txBox="1"/>
            <p:nvPr/>
          </p:nvSpPr>
          <p:spPr>
            <a:xfrm>
              <a:off x="2722057" y="1854903"/>
              <a:ext cx="876721" cy="69250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r>
                <a:rPr lang="en-US" sz="450" i="1" dirty="0"/>
                <a:t>P. aquatica </a:t>
              </a:r>
              <a:r>
                <a:rPr lang="en-US" sz="450" dirty="0"/>
                <a:t>(JF951056.1) </a:t>
              </a:r>
            </a:p>
          </p:txBody>
        </p:sp>
        <p:sp>
          <p:nvSpPr>
            <p:cNvPr id="42" name="TextBox 41"/>
            <p:cNvSpPr txBox="1"/>
            <p:nvPr/>
          </p:nvSpPr>
          <p:spPr>
            <a:xfrm>
              <a:off x="2718570" y="2139359"/>
              <a:ext cx="853348" cy="69250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r>
                <a:rPr lang="en-US" sz="450" i="1" dirty="0"/>
                <a:t>P. aquatica </a:t>
              </a:r>
              <a:r>
                <a:rPr lang="en-US" sz="450" dirty="0"/>
                <a:t>(JF951076.1) </a:t>
              </a:r>
            </a:p>
          </p:txBody>
        </p:sp>
        <p:sp>
          <p:nvSpPr>
            <p:cNvPr id="43" name="TextBox 42"/>
            <p:cNvSpPr txBox="1"/>
            <p:nvPr/>
          </p:nvSpPr>
          <p:spPr>
            <a:xfrm>
              <a:off x="2721806" y="1968448"/>
              <a:ext cx="876721" cy="69250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r>
                <a:rPr lang="en-US" sz="450" i="1" dirty="0"/>
                <a:t>P. aquatica </a:t>
              </a:r>
              <a:r>
                <a:rPr lang="en-US" sz="450" dirty="0"/>
                <a:t>(KC512901.1) </a:t>
              </a:r>
            </a:p>
          </p:txBody>
        </p:sp>
        <p:sp>
          <p:nvSpPr>
            <p:cNvPr id="44" name="TextBox 43"/>
            <p:cNvSpPr txBox="1"/>
            <p:nvPr/>
          </p:nvSpPr>
          <p:spPr>
            <a:xfrm>
              <a:off x="2725039" y="1794523"/>
              <a:ext cx="832829" cy="69250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r>
                <a:rPr lang="en-US" sz="450" i="1" dirty="0"/>
                <a:t>P. aquatica </a:t>
              </a:r>
              <a:r>
                <a:rPr lang="en-US" sz="450" dirty="0"/>
                <a:t>(KF753775.1) </a:t>
              </a:r>
            </a:p>
          </p:txBody>
        </p:sp>
        <p:sp>
          <p:nvSpPr>
            <p:cNvPr id="45" name="TextBox 44"/>
            <p:cNvSpPr txBox="1"/>
            <p:nvPr/>
          </p:nvSpPr>
          <p:spPr>
            <a:xfrm>
              <a:off x="2721813" y="1913868"/>
              <a:ext cx="846954" cy="69250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r>
                <a:rPr lang="en-US" sz="450" i="1" dirty="0"/>
                <a:t>P. aquatica </a:t>
              </a:r>
              <a:r>
                <a:rPr lang="en-US" sz="450" dirty="0"/>
                <a:t>(KF753776.1) </a:t>
              </a:r>
            </a:p>
          </p:txBody>
        </p:sp>
        <p:sp>
          <p:nvSpPr>
            <p:cNvPr id="46" name="TextBox 45"/>
            <p:cNvSpPr txBox="1"/>
            <p:nvPr/>
          </p:nvSpPr>
          <p:spPr>
            <a:xfrm>
              <a:off x="2719902" y="2252338"/>
              <a:ext cx="876722" cy="69250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r>
                <a:rPr lang="en-US" sz="450" i="1" dirty="0"/>
                <a:t>P. aquatica </a:t>
              </a:r>
              <a:r>
                <a:rPr lang="en-US" sz="450" dirty="0"/>
                <a:t>(KX873130.1) </a:t>
              </a:r>
            </a:p>
          </p:txBody>
        </p:sp>
        <p:sp>
          <p:nvSpPr>
            <p:cNvPr id="47" name="TextBox 46"/>
            <p:cNvSpPr txBox="1"/>
            <p:nvPr/>
          </p:nvSpPr>
          <p:spPr>
            <a:xfrm>
              <a:off x="2718315" y="3731810"/>
              <a:ext cx="833487" cy="70365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r>
                <a:rPr lang="en-US" sz="450" i="1" dirty="0"/>
                <a:t>P. paradoxa </a:t>
              </a:r>
              <a:r>
                <a:rPr lang="en-US" sz="450" dirty="0"/>
                <a:t>(KF753783.1) </a:t>
              </a:r>
            </a:p>
          </p:txBody>
        </p:sp>
        <p:sp>
          <p:nvSpPr>
            <p:cNvPr id="48" name="TextBox 47"/>
            <p:cNvSpPr txBox="1"/>
            <p:nvPr/>
          </p:nvSpPr>
          <p:spPr>
            <a:xfrm>
              <a:off x="2724437" y="3165608"/>
              <a:ext cx="760658" cy="69250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r>
                <a:rPr lang="en-US" sz="450" i="1" dirty="0"/>
                <a:t>P. minor </a:t>
              </a:r>
              <a:r>
                <a:rPr lang="en-US" sz="450" dirty="0"/>
                <a:t>(MN811193.1) </a:t>
              </a:r>
            </a:p>
          </p:txBody>
        </p:sp>
        <p:sp>
          <p:nvSpPr>
            <p:cNvPr id="49" name="TextBox 48"/>
            <p:cNvSpPr txBox="1"/>
            <p:nvPr/>
          </p:nvSpPr>
          <p:spPr>
            <a:xfrm>
              <a:off x="2726552" y="3108894"/>
              <a:ext cx="760658" cy="69250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r>
                <a:rPr lang="en-US" sz="450" i="1" dirty="0"/>
                <a:t>P. minor </a:t>
              </a:r>
              <a:r>
                <a:rPr lang="en-US" sz="450" dirty="0"/>
                <a:t>(KX873131.1) </a:t>
              </a:r>
            </a:p>
          </p:txBody>
        </p:sp>
        <p:sp>
          <p:nvSpPr>
            <p:cNvPr id="50" name="TextBox 49"/>
            <p:cNvSpPr txBox="1"/>
            <p:nvPr/>
          </p:nvSpPr>
          <p:spPr>
            <a:xfrm>
              <a:off x="2720794" y="2475472"/>
              <a:ext cx="760658" cy="69250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r>
                <a:rPr lang="en-US" sz="450" i="1" dirty="0"/>
                <a:t>P. coerulescens </a:t>
              </a:r>
              <a:r>
                <a:rPr lang="en-US" sz="450" dirty="0"/>
                <a:t>(DQ539581.1) </a:t>
              </a:r>
            </a:p>
          </p:txBody>
        </p:sp>
        <p:sp>
          <p:nvSpPr>
            <p:cNvPr id="51" name="TextBox 50"/>
            <p:cNvSpPr txBox="1"/>
            <p:nvPr/>
          </p:nvSpPr>
          <p:spPr>
            <a:xfrm>
              <a:off x="2721233" y="2418762"/>
              <a:ext cx="760658" cy="69250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r>
                <a:rPr lang="en-US" sz="450" i="1" dirty="0"/>
                <a:t>P. coerulescens </a:t>
              </a:r>
              <a:r>
                <a:rPr lang="en-US" sz="450" dirty="0"/>
                <a:t>(JF951066.1) </a:t>
              </a:r>
            </a:p>
          </p:txBody>
        </p:sp>
        <p:sp>
          <p:nvSpPr>
            <p:cNvPr id="52" name="TextBox 51"/>
            <p:cNvSpPr txBox="1"/>
            <p:nvPr/>
          </p:nvSpPr>
          <p:spPr>
            <a:xfrm>
              <a:off x="2722909" y="2363673"/>
              <a:ext cx="760658" cy="69250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r>
                <a:rPr lang="en-US" sz="450" i="1" dirty="0"/>
                <a:t>P. coerulescens </a:t>
              </a:r>
              <a:r>
                <a:rPr lang="en-US" sz="450" dirty="0"/>
                <a:t>(JF951081.1) </a:t>
              </a:r>
            </a:p>
          </p:txBody>
        </p:sp>
        <p:sp>
          <p:nvSpPr>
            <p:cNvPr id="53" name="TextBox 52"/>
            <p:cNvSpPr txBox="1"/>
            <p:nvPr/>
          </p:nvSpPr>
          <p:spPr>
            <a:xfrm>
              <a:off x="2724053" y="2705636"/>
              <a:ext cx="760658" cy="69250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r>
                <a:rPr lang="en-US" sz="450" i="1" dirty="0"/>
                <a:t>P. coerulescens </a:t>
              </a:r>
              <a:r>
                <a:rPr lang="en-US" sz="450" dirty="0"/>
                <a:t>(KF753782.1) </a:t>
              </a:r>
            </a:p>
          </p:txBody>
        </p:sp>
        <p:sp>
          <p:nvSpPr>
            <p:cNvPr id="54" name="TextBox 53"/>
            <p:cNvSpPr txBox="1"/>
            <p:nvPr/>
          </p:nvSpPr>
          <p:spPr>
            <a:xfrm>
              <a:off x="2722593" y="3333984"/>
              <a:ext cx="723079" cy="69250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r>
                <a:rPr lang="en-US" sz="450" i="1" dirty="0">
                  <a:solidFill>
                    <a:srgbClr val="FF0000"/>
                  </a:solidFill>
                </a:rPr>
                <a:t>P. minor </a:t>
              </a:r>
              <a:r>
                <a:rPr lang="en-US" sz="450" dirty="0">
                  <a:solidFill>
                    <a:srgbClr val="FF0000"/>
                  </a:solidFill>
                </a:rPr>
                <a:t>(JF951086.1) </a:t>
              </a:r>
            </a:p>
          </p:txBody>
        </p:sp>
        <p:sp>
          <p:nvSpPr>
            <p:cNvPr id="55" name="TextBox 54"/>
            <p:cNvSpPr txBox="1"/>
            <p:nvPr/>
          </p:nvSpPr>
          <p:spPr>
            <a:xfrm>
              <a:off x="2730312" y="2769642"/>
              <a:ext cx="760658" cy="69250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r>
                <a:rPr lang="en-US" sz="450" i="1" dirty="0"/>
                <a:t>P. minor </a:t>
              </a:r>
              <a:r>
                <a:rPr lang="en-US" sz="450" dirty="0"/>
                <a:t>(JF907187.1) </a:t>
              </a:r>
            </a:p>
          </p:txBody>
        </p:sp>
        <p:sp>
          <p:nvSpPr>
            <p:cNvPr id="56" name="TextBox 55"/>
            <p:cNvSpPr txBox="1"/>
            <p:nvPr/>
          </p:nvSpPr>
          <p:spPr>
            <a:xfrm>
              <a:off x="2729285" y="2818884"/>
              <a:ext cx="760658" cy="69250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r>
                <a:rPr lang="en-US" sz="450" i="1" dirty="0">
                  <a:solidFill>
                    <a:srgbClr val="FF0000"/>
                  </a:solidFill>
                </a:rPr>
                <a:t>P. paradoxa </a:t>
              </a:r>
              <a:r>
                <a:rPr lang="en-US" sz="450" dirty="0">
                  <a:solidFill>
                    <a:srgbClr val="FF0000"/>
                  </a:solidFill>
                </a:rPr>
                <a:t>(JF951070.1) </a:t>
              </a:r>
            </a:p>
          </p:txBody>
        </p:sp>
        <p:sp>
          <p:nvSpPr>
            <p:cNvPr id="57" name="TextBox 56"/>
            <p:cNvSpPr txBox="1"/>
            <p:nvPr/>
          </p:nvSpPr>
          <p:spPr>
            <a:xfrm>
              <a:off x="2723373" y="995998"/>
              <a:ext cx="875405" cy="69250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r>
                <a:rPr lang="en-US" sz="450" i="1" dirty="0"/>
                <a:t>P. canariensis </a:t>
              </a:r>
              <a:r>
                <a:rPr lang="en-US" sz="450" dirty="0"/>
                <a:t>(DQ539580.1) </a:t>
              </a:r>
            </a:p>
          </p:txBody>
        </p:sp>
        <p:sp>
          <p:nvSpPr>
            <p:cNvPr id="58" name="TextBox 57"/>
            <p:cNvSpPr txBox="1"/>
            <p:nvPr/>
          </p:nvSpPr>
          <p:spPr>
            <a:xfrm>
              <a:off x="2720225" y="1057610"/>
              <a:ext cx="832170" cy="69250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r>
                <a:rPr lang="en-US" sz="450" i="1" dirty="0"/>
                <a:t>P. canariensis </a:t>
              </a:r>
              <a:r>
                <a:rPr lang="en-US" sz="450" dirty="0"/>
                <a:t>(FJ178782.1) </a:t>
              </a:r>
            </a:p>
          </p:txBody>
        </p:sp>
        <p:sp>
          <p:nvSpPr>
            <p:cNvPr id="59" name="TextBox 58"/>
            <p:cNvSpPr txBox="1"/>
            <p:nvPr/>
          </p:nvSpPr>
          <p:spPr>
            <a:xfrm>
              <a:off x="2718570" y="1113943"/>
              <a:ext cx="876063" cy="69250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r>
                <a:rPr lang="en-US" sz="450" i="1" dirty="0"/>
                <a:t>P. canariensis </a:t>
              </a:r>
              <a:r>
                <a:rPr lang="en-US" sz="450" dirty="0"/>
                <a:t>(JF951058.1) </a:t>
              </a:r>
            </a:p>
          </p:txBody>
        </p:sp>
        <p:sp>
          <p:nvSpPr>
            <p:cNvPr id="60" name="TextBox 59"/>
            <p:cNvSpPr txBox="1"/>
            <p:nvPr/>
          </p:nvSpPr>
          <p:spPr>
            <a:xfrm>
              <a:off x="2723379" y="1678028"/>
              <a:ext cx="876063" cy="69250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r>
                <a:rPr lang="en-US" sz="450" i="1" dirty="0"/>
                <a:t>P. canariensis </a:t>
              </a:r>
              <a:r>
                <a:rPr lang="en-US" sz="450" dirty="0"/>
                <a:t>(KP296086.1) </a:t>
              </a:r>
            </a:p>
          </p:txBody>
        </p:sp>
        <p:sp>
          <p:nvSpPr>
            <p:cNvPr id="61" name="TextBox 60"/>
            <p:cNvSpPr txBox="1"/>
            <p:nvPr/>
          </p:nvSpPr>
          <p:spPr>
            <a:xfrm>
              <a:off x="2723328" y="1624998"/>
              <a:ext cx="876063" cy="69250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r>
                <a:rPr lang="en-US" sz="450" i="1" dirty="0"/>
                <a:t>P. canariensis </a:t>
              </a:r>
              <a:r>
                <a:rPr lang="en-US" sz="450" dirty="0"/>
                <a:t>(KX147537.1) </a:t>
              </a:r>
            </a:p>
          </p:txBody>
        </p:sp>
        <p:sp>
          <p:nvSpPr>
            <p:cNvPr id="62" name="TextBox 61"/>
            <p:cNvSpPr txBox="1"/>
            <p:nvPr/>
          </p:nvSpPr>
          <p:spPr>
            <a:xfrm>
              <a:off x="2724829" y="936764"/>
              <a:ext cx="831403" cy="69250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r>
                <a:rPr lang="en-US" sz="450" i="1" dirty="0"/>
                <a:t>P. canariensis </a:t>
              </a:r>
              <a:r>
                <a:rPr lang="en-US" sz="450" dirty="0"/>
                <a:t>(KX147547.1) </a:t>
              </a:r>
            </a:p>
          </p:txBody>
        </p:sp>
        <p:sp>
          <p:nvSpPr>
            <p:cNvPr id="63" name="TextBox 62"/>
            <p:cNvSpPr txBox="1"/>
            <p:nvPr/>
          </p:nvSpPr>
          <p:spPr>
            <a:xfrm>
              <a:off x="2721924" y="1168211"/>
              <a:ext cx="923197" cy="69250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r>
                <a:rPr lang="en-US" sz="450" i="1" dirty="0"/>
                <a:t>P. brachystachys </a:t>
              </a:r>
              <a:r>
                <a:rPr lang="en-US" sz="450" dirty="0"/>
                <a:t>(JF951057.1) </a:t>
              </a:r>
            </a:p>
          </p:txBody>
        </p:sp>
        <p:sp>
          <p:nvSpPr>
            <p:cNvPr id="64" name="TextBox 63"/>
            <p:cNvSpPr txBox="1"/>
            <p:nvPr/>
          </p:nvSpPr>
          <p:spPr>
            <a:xfrm>
              <a:off x="2714927" y="821958"/>
              <a:ext cx="831074" cy="69250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r>
                <a:rPr lang="en-US" sz="450" i="1" dirty="0"/>
                <a:t>P. brachystachys </a:t>
              </a:r>
              <a:r>
                <a:rPr lang="en-US" sz="450" dirty="0"/>
                <a:t>(KC512902.1) </a:t>
              </a:r>
            </a:p>
          </p:txBody>
        </p:sp>
        <p:sp>
          <p:nvSpPr>
            <p:cNvPr id="65" name="TextBox 64"/>
            <p:cNvSpPr txBox="1"/>
            <p:nvPr/>
          </p:nvSpPr>
          <p:spPr>
            <a:xfrm>
              <a:off x="2721321" y="877176"/>
              <a:ext cx="831074" cy="69250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r>
                <a:rPr lang="en-US" sz="450" i="1" dirty="0"/>
                <a:t>P. brachystachys </a:t>
              </a:r>
              <a:r>
                <a:rPr lang="en-US" sz="450" dirty="0"/>
                <a:t>(KF753780.1) </a:t>
              </a:r>
            </a:p>
          </p:txBody>
        </p:sp>
        <p:sp>
          <p:nvSpPr>
            <p:cNvPr id="66" name="TextBox 65"/>
            <p:cNvSpPr txBox="1"/>
            <p:nvPr/>
          </p:nvSpPr>
          <p:spPr>
            <a:xfrm>
              <a:off x="2720232" y="590924"/>
              <a:ext cx="761510" cy="69250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r>
                <a:rPr lang="en-US" sz="450" i="1" dirty="0"/>
                <a:t>P. truncata </a:t>
              </a:r>
              <a:r>
                <a:rPr lang="en-US" sz="450" dirty="0"/>
                <a:t>(KC512903.1) </a:t>
              </a:r>
            </a:p>
          </p:txBody>
        </p:sp>
        <p:sp>
          <p:nvSpPr>
            <p:cNvPr id="67" name="TextBox 66"/>
            <p:cNvSpPr txBox="1"/>
            <p:nvPr/>
          </p:nvSpPr>
          <p:spPr>
            <a:xfrm>
              <a:off x="2720232" y="483798"/>
              <a:ext cx="761510" cy="69250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r>
                <a:rPr lang="en-US" sz="450" i="1" dirty="0"/>
                <a:t>P. truncata </a:t>
              </a:r>
              <a:r>
                <a:rPr lang="en-US" sz="450" dirty="0"/>
                <a:t>(L36522.1) </a:t>
              </a:r>
            </a:p>
          </p:txBody>
        </p:sp>
        <p:cxnSp>
          <p:nvCxnSpPr>
            <p:cNvPr id="68" name="Straight Connector 67"/>
            <p:cNvCxnSpPr/>
            <p:nvPr/>
          </p:nvCxnSpPr>
          <p:spPr>
            <a:xfrm flipV="1">
              <a:off x="1666460" y="1743675"/>
              <a:ext cx="7680960" cy="0"/>
            </a:xfrm>
            <a:prstGeom prst="line">
              <a:avLst/>
            </a:prstGeom>
            <a:ln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9" name="Straight Connector 68"/>
            <p:cNvCxnSpPr/>
            <p:nvPr/>
          </p:nvCxnSpPr>
          <p:spPr>
            <a:xfrm flipV="1">
              <a:off x="1666460" y="2373120"/>
              <a:ext cx="7680960" cy="0"/>
            </a:xfrm>
            <a:prstGeom prst="line">
              <a:avLst/>
            </a:prstGeom>
            <a:ln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70" name="TextBox 69"/>
            <p:cNvSpPr txBox="1"/>
            <p:nvPr/>
          </p:nvSpPr>
          <p:spPr>
            <a:xfrm>
              <a:off x="2723914" y="2652131"/>
              <a:ext cx="760658" cy="69250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r>
                <a:rPr lang="en-US" sz="450" i="1" dirty="0"/>
                <a:t>P. coerulescens </a:t>
              </a:r>
              <a:r>
                <a:rPr lang="en-US" sz="450" dirty="0"/>
                <a:t>(HE802172.1) </a:t>
              </a:r>
            </a:p>
          </p:txBody>
        </p:sp>
        <p:sp>
          <p:nvSpPr>
            <p:cNvPr id="71" name="TextBox 70"/>
            <p:cNvSpPr txBox="1"/>
            <p:nvPr/>
          </p:nvSpPr>
          <p:spPr>
            <a:xfrm>
              <a:off x="2722909" y="2595542"/>
              <a:ext cx="760658" cy="69250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r>
                <a:rPr lang="en-US" sz="450" i="1" dirty="0"/>
                <a:t>P. coerulescens </a:t>
              </a:r>
              <a:r>
                <a:rPr lang="en-US" sz="450" dirty="0"/>
                <a:t>(KC512900.1) </a:t>
              </a:r>
            </a:p>
          </p:txBody>
        </p:sp>
        <p:cxnSp>
          <p:nvCxnSpPr>
            <p:cNvPr id="72" name="Straight Connector 71"/>
            <p:cNvCxnSpPr/>
            <p:nvPr/>
          </p:nvCxnSpPr>
          <p:spPr>
            <a:xfrm flipV="1">
              <a:off x="1659737" y="2771182"/>
              <a:ext cx="7680960" cy="0"/>
            </a:xfrm>
            <a:prstGeom prst="line">
              <a:avLst/>
            </a:prstGeom>
            <a:ln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73" name="TextBox 72"/>
            <p:cNvSpPr txBox="1"/>
            <p:nvPr/>
          </p:nvSpPr>
          <p:spPr>
            <a:xfrm>
              <a:off x="2731222" y="3050562"/>
              <a:ext cx="760658" cy="69250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r>
                <a:rPr lang="en-US" sz="450" i="1" dirty="0"/>
                <a:t>P. minor </a:t>
              </a:r>
              <a:r>
                <a:rPr lang="en-US" sz="450" dirty="0"/>
                <a:t>(JF907187.1) </a:t>
              </a:r>
            </a:p>
          </p:txBody>
        </p:sp>
        <p:sp>
          <p:nvSpPr>
            <p:cNvPr id="74" name="TextBox 73"/>
            <p:cNvSpPr txBox="1"/>
            <p:nvPr/>
          </p:nvSpPr>
          <p:spPr>
            <a:xfrm>
              <a:off x="2728956" y="2993892"/>
              <a:ext cx="760658" cy="69250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r>
                <a:rPr lang="en-US" sz="450" i="1" dirty="0"/>
                <a:t>P. minor </a:t>
              </a:r>
              <a:r>
                <a:rPr lang="en-US" sz="450" dirty="0"/>
                <a:t>(JF951069.1) </a:t>
              </a:r>
            </a:p>
          </p:txBody>
        </p:sp>
        <p:sp>
          <p:nvSpPr>
            <p:cNvPr id="75" name="TextBox 74"/>
            <p:cNvSpPr txBox="1"/>
            <p:nvPr/>
          </p:nvSpPr>
          <p:spPr>
            <a:xfrm>
              <a:off x="2728080" y="2939632"/>
              <a:ext cx="760658" cy="69250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r>
                <a:rPr lang="en-US" sz="450" i="1" dirty="0"/>
                <a:t>P. minor </a:t>
              </a:r>
              <a:r>
                <a:rPr lang="en-US" sz="450" dirty="0"/>
                <a:t>(JF951084.1) </a:t>
              </a:r>
            </a:p>
          </p:txBody>
        </p:sp>
        <p:sp>
          <p:nvSpPr>
            <p:cNvPr id="76" name="TextBox 75"/>
            <p:cNvSpPr txBox="1"/>
            <p:nvPr/>
          </p:nvSpPr>
          <p:spPr>
            <a:xfrm>
              <a:off x="2721527" y="3847045"/>
              <a:ext cx="797306" cy="69250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r>
                <a:rPr lang="en-US" sz="450" i="1" dirty="0"/>
                <a:t>P. paradoxa </a:t>
              </a:r>
              <a:r>
                <a:rPr lang="en-US" sz="450" dirty="0"/>
                <a:t>(KC512899.1) </a:t>
              </a:r>
            </a:p>
          </p:txBody>
        </p:sp>
        <p:sp>
          <p:nvSpPr>
            <p:cNvPr id="77" name="TextBox 76"/>
            <p:cNvSpPr txBox="1"/>
            <p:nvPr/>
          </p:nvSpPr>
          <p:spPr>
            <a:xfrm>
              <a:off x="2719902" y="3789368"/>
              <a:ext cx="846630" cy="69250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r>
                <a:rPr lang="en-US" sz="450" i="1" dirty="0"/>
                <a:t>P. paradoxa </a:t>
              </a:r>
              <a:r>
                <a:rPr lang="en-US" sz="450" dirty="0"/>
                <a:t>(JF951089.1) </a:t>
              </a:r>
            </a:p>
          </p:txBody>
        </p:sp>
        <p:sp>
          <p:nvSpPr>
            <p:cNvPr id="78" name="TextBox 77"/>
            <p:cNvSpPr txBox="1"/>
            <p:nvPr/>
          </p:nvSpPr>
          <p:spPr>
            <a:xfrm>
              <a:off x="2724068" y="3278194"/>
              <a:ext cx="870001" cy="69250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r>
                <a:rPr lang="en-US" sz="450" i="1" dirty="0"/>
                <a:t>P. paradoxa </a:t>
              </a:r>
              <a:r>
                <a:rPr lang="en-US" sz="450" dirty="0"/>
                <a:t>(JF951071.1) </a:t>
              </a:r>
            </a:p>
          </p:txBody>
        </p:sp>
        <p:cxnSp>
          <p:nvCxnSpPr>
            <p:cNvPr id="79" name="Straight Connector 78"/>
            <p:cNvCxnSpPr/>
            <p:nvPr/>
          </p:nvCxnSpPr>
          <p:spPr>
            <a:xfrm flipV="1">
              <a:off x="1666460" y="3284853"/>
              <a:ext cx="7680960" cy="0"/>
            </a:xfrm>
            <a:prstGeom prst="line">
              <a:avLst/>
            </a:prstGeom>
            <a:ln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80" name="TextBox 79"/>
            <p:cNvSpPr txBox="1"/>
            <p:nvPr/>
          </p:nvSpPr>
          <p:spPr>
            <a:xfrm>
              <a:off x="2720182" y="3673903"/>
              <a:ext cx="761550" cy="69250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r>
                <a:rPr lang="en-US" sz="450" i="1" dirty="0"/>
                <a:t>P. paradoxa </a:t>
              </a:r>
              <a:r>
                <a:rPr lang="en-US" sz="450" dirty="0"/>
                <a:t>(JF951088.1) </a:t>
              </a:r>
            </a:p>
          </p:txBody>
        </p:sp>
        <p:sp>
          <p:nvSpPr>
            <p:cNvPr id="81" name="TextBox 80"/>
            <p:cNvSpPr txBox="1"/>
            <p:nvPr/>
          </p:nvSpPr>
          <p:spPr>
            <a:xfrm>
              <a:off x="2719902" y="3621150"/>
              <a:ext cx="726221" cy="69250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r>
                <a:rPr lang="en-US" sz="450" i="1" dirty="0"/>
                <a:t>P. paradoxa </a:t>
              </a:r>
              <a:r>
                <a:rPr lang="en-US" sz="450" dirty="0"/>
                <a:t>(KX873132.1) </a:t>
              </a:r>
            </a:p>
          </p:txBody>
        </p:sp>
        <p:sp>
          <p:nvSpPr>
            <p:cNvPr id="82" name="TextBox 81"/>
            <p:cNvSpPr txBox="1"/>
            <p:nvPr/>
          </p:nvSpPr>
          <p:spPr>
            <a:xfrm>
              <a:off x="2722085" y="3562760"/>
              <a:ext cx="766830" cy="69250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r>
                <a:rPr lang="en-US" sz="450" i="1" dirty="0"/>
                <a:t>P. paradoxa </a:t>
              </a:r>
              <a:r>
                <a:rPr lang="en-US" sz="450" dirty="0"/>
                <a:t>(KX873133.1) </a:t>
              </a:r>
            </a:p>
          </p:txBody>
        </p:sp>
        <p:sp>
          <p:nvSpPr>
            <p:cNvPr id="83" name="TextBox 82"/>
            <p:cNvSpPr txBox="1"/>
            <p:nvPr/>
          </p:nvSpPr>
          <p:spPr>
            <a:xfrm>
              <a:off x="2728582" y="3506978"/>
              <a:ext cx="685042" cy="69250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r>
                <a:rPr lang="en-US" sz="450" i="1" dirty="0">
                  <a:solidFill>
                    <a:srgbClr val="FF0000"/>
                  </a:solidFill>
                </a:rPr>
                <a:t>P. aquatica </a:t>
              </a:r>
              <a:r>
                <a:rPr lang="en-US" sz="450" dirty="0">
                  <a:solidFill>
                    <a:srgbClr val="FF0000"/>
                  </a:solidFill>
                </a:rPr>
                <a:t>(KU883516.1) </a:t>
              </a:r>
            </a:p>
          </p:txBody>
        </p:sp>
        <p:cxnSp>
          <p:nvCxnSpPr>
            <p:cNvPr id="84" name="Straight Connector 83"/>
            <p:cNvCxnSpPr/>
            <p:nvPr/>
          </p:nvCxnSpPr>
          <p:spPr>
            <a:xfrm flipV="1">
              <a:off x="1663214" y="3918030"/>
              <a:ext cx="7680960" cy="0"/>
            </a:xfrm>
            <a:prstGeom prst="line">
              <a:avLst/>
            </a:prstGeom>
            <a:ln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5" name="Straight Connector 84"/>
            <p:cNvCxnSpPr/>
            <p:nvPr/>
          </p:nvCxnSpPr>
          <p:spPr>
            <a:xfrm flipV="1">
              <a:off x="1663278" y="6376761"/>
              <a:ext cx="7680960" cy="0"/>
            </a:xfrm>
            <a:prstGeom prst="line">
              <a:avLst/>
            </a:prstGeom>
            <a:ln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6" name="Straight Connector 85"/>
            <p:cNvCxnSpPr/>
            <p:nvPr/>
          </p:nvCxnSpPr>
          <p:spPr>
            <a:xfrm flipV="1">
              <a:off x="1663042" y="6138657"/>
              <a:ext cx="7680960" cy="0"/>
            </a:xfrm>
            <a:prstGeom prst="line">
              <a:avLst/>
            </a:prstGeom>
            <a:ln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87" name="TextBox 86"/>
            <p:cNvSpPr txBox="1"/>
            <p:nvPr/>
          </p:nvSpPr>
          <p:spPr>
            <a:xfrm>
              <a:off x="2712181" y="5959785"/>
              <a:ext cx="688515" cy="69250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r>
                <a:rPr lang="en-US" sz="450" i="1" dirty="0"/>
                <a:t>P. lemmonii </a:t>
              </a:r>
              <a:r>
                <a:rPr lang="en-US" sz="450" dirty="0"/>
                <a:t>(MF964010.1) </a:t>
              </a:r>
            </a:p>
          </p:txBody>
        </p:sp>
        <p:sp>
          <p:nvSpPr>
            <p:cNvPr id="88" name="TextBox 87"/>
            <p:cNvSpPr txBox="1"/>
            <p:nvPr/>
          </p:nvSpPr>
          <p:spPr>
            <a:xfrm>
              <a:off x="2723539" y="3958534"/>
              <a:ext cx="729364" cy="69250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r>
                <a:rPr lang="en-US" sz="450" i="1" dirty="0"/>
                <a:t>P. arundinacea </a:t>
              </a:r>
              <a:r>
                <a:rPr lang="en-US" sz="450" dirty="0"/>
                <a:t>(KF713250.1) </a:t>
              </a:r>
            </a:p>
          </p:txBody>
        </p:sp>
        <p:cxnSp>
          <p:nvCxnSpPr>
            <p:cNvPr id="89" name="Straight Connector 88"/>
            <p:cNvCxnSpPr/>
            <p:nvPr/>
          </p:nvCxnSpPr>
          <p:spPr>
            <a:xfrm flipV="1">
              <a:off x="1664103" y="5057623"/>
              <a:ext cx="7680960" cy="0"/>
            </a:xfrm>
            <a:prstGeom prst="line">
              <a:avLst/>
            </a:prstGeom>
            <a:ln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90" name="TextBox 89"/>
            <p:cNvSpPr txBox="1"/>
            <p:nvPr/>
          </p:nvSpPr>
          <p:spPr>
            <a:xfrm>
              <a:off x="2723540" y="4013962"/>
              <a:ext cx="729364" cy="69250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r>
                <a:rPr lang="en-US" sz="450" i="1" dirty="0"/>
                <a:t>P. arundinacea </a:t>
              </a:r>
              <a:r>
                <a:rPr lang="en-US" sz="450" dirty="0"/>
                <a:t>(KF753778.1) </a:t>
              </a:r>
            </a:p>
          </p:txBody>
        </p:sp>
        <p:sp>
          <p:nvSpPr>
            <p:cNvPr id="91" name="TextBox 90"/>
            <p:cNvSpPr txBox="1"/>
            <p:nvPr/>
          </p:nvSpPr>
          <p:spPr>
            <a:xfrm>
              <a:off x="2723540" y="4068639"/>
              <a:ext cx="729364" cy="69250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r>
                <a:rPr lang="en-US" sz="450" i="1" dirty="0"/>
                <a:t>P. arundinacea </a:t>
              </a:r>
              <a:r>
                <a:rPr lang="en-US" sz="450" dirty="0"/>
                <a:t>(HQ600518.1) </a:t>
              </a:r>
            </a:p>
          </p:txBody>
        </p:sp>
        <p:sp>
          <p:nvSpPr>
            <p:cNvPr id="92" name="TextBox 91"/>
            <p:cNvSpPr txBox="1"/>
            <p:nvPr/>
          </p:nvSpPr>
          <p:spPr>
            <a:xfrm>
              <a:off x="2718570" y="4310540"/>
              <a:ext cx="692680" cy="71677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r>
                <a:rPr lang="en-US" sz="450" i="1" dirty="0"/>
                <a:t>P. arundinacea </a:t>
              </a:r>
              <a:r>
                <a:rPr lang="en-US" sz="450" dirty="0"/>
                <a:t>(FJ821785.1) </a:t>
              </a:r>
            </a:p>
          </p:txBody>
        </p:sp>
        <p:sp>
          <p:nvSpPr>
            <p:cNvPr id="93" name="TextBox 92"/>
            <p:cNvSpPr txBox="1"/>
            <p:nvPr/>
          </p:nvSpPr>
          <p:spPr>
            <a:xfrm>
              <a:off x="2718570" y="4818166"/>
              <a:ext cx="737614" cy="69250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r>
                <a:rPr lang="en-US" sz="450" i="1" dirty="0"/>
                <a:t>P. arundinacea </a:t>
              </a:r>
              <a:r>
                <a:rPr lang="en-US" sz="450" dirty="0"/>
                <a:t>(FJ766174.1) </a:t>
              </a:r>
            </a:p>
          </p:txBody>
        </p:sp>
        <p:sp>
          <p:nvSpPr>
            <p:cNvPr id="95" name="TextBox 94"/>
            <p:cNvSpPr txBox="1"/>
            <p:nvPr/>
          </p:nvSpPr>
          <p:spPr>
            <a:xfrm>
              <a:off x="2715897" y="539168"/>
              <a:ext cx="761510" cy="69250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r>
                <a:rPr lang="en-US" sz="450" i="1" dirty="0"/>
                <a:t>P. </a:t>
              </a:r>
              <a:r>
                <a:rPr lang="en-US" sz="450" i="1" dirty="0" err="1"/>
                <a:t>truncata</a:t>
              </a:r>
              <a:r>
                <a:rPr lang="en-US" sz="450" i="1" dirty="0"/>
                <a:t> (</a:t>
              </a:r>
              <a:r>
                <a:rPr lang="en-US" sz="450" dirty="0"/>
                <a:t>MN811196.1) </a:t>
              </a:r>
            </a:p>
          </p:txBody>
        </p:sp>
        <p:sp>
          <p:nvSpPr>
            <p:cNvPr id="96" name="TextBox 95"/>
            <p:cNvSpPr txBox="1"/>
            <p:nvPr/>
          </p:nvSpPr>
          <p:spPr>
            <a:xfrm>
              <a:off x="2718951" y="704176"/>
              <a:ext cx="761839" cy="69250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r>
                <a:rPr lang="en-US" sz="450" i="1" dirty="0"/>
                <a:t>P. </a:t>
              </a:r>
              <a:r>
                <a:rPr lang="en-US" sz="450" i="1" dirty="0" err="1"/>
                <a:t>truncata</a:t>
              </a:r>
              <a:r>
                <a:rPr lang="en-US" sz="450" i="1" dirty="0"/>
                <a:t> </a:t>
              </a:r>
              <a:r>
                <a:rPr lang="en-US" sz="450" dirty="0"/>
                <a:t>(MN811197.1) </a:t>
              </a:r>
            </a:p>
          </p:txBody>
        </p:sp>
        <p:sp>
          <p:nvSpPr>
            <p:cNvPr id="97" name="TextBox 96"/>
            <p:cNvSpPr txBox="1"/>
            <p:nvPr/>
          </p:nvSpPr>
          <p:spPr>
            <a:xfrm>
              <a:off x="2719902" y="648073"/>
              <a:ext cx="761839" cy="69250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r>
                <a:rPr lang="en-US" sz="450" i="1" dirty="0"/>
                <a:t>P. truncata </a:t>
              </a:r>
              <a:r>
                <a:rPr lang="en-US" sz="450" dirty="0"/>
                <a:t>(JF951059.1) </a:t>
              </a:r>
            </a:p>
          </p:txBody>
        </p:sp>
        <p:sp>
          <p:nvSpPr>
            <p:cNvPr id="98" name="TextBox 97"/>
            <p:cNvSpPr txBox="1"/>
            <p:nvPr/>
          </p:nvSpPr>
          <p:spPr>
            <a:xfrm>
              <a:off x="2718950" y="759804"/>
              <a:ext cx="761839" cy="69250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r>
                <a:rPr lang="en-US" sz="450" i="1" dirty="0"/>
                <a:t>P. </a:t>
              </a:r>
              <a:r>
                <a:rPr lang="en-US" sz="450" i="1" dirty="0" err="1"/>
                <a:t>truncata</a:t>
              </a:r>
              <a:r>
                <a:rPr lang="en-US" sz="450" i="1" dirty="0"/>
                <a:t> </a:t>
              </a:r>
              <a:r>
                <a:rPr lang="en-US" sz="450" dirty="0"/>
                <a:t>(MN811198.1) </a:t>
              </a:r>
            </a:p>
          </p:txBody>
        </p:sp>
        <p:cxnSp>
          <p:nvCxnSpPr>
            <p:cNvPr id="99" name="Straight Connector 98"/>
            <p:cNvCxnSpPr/>
            <p:nvPr/>
          </p:nvCxnSpPr>
          <p:spPr>
            <a:xfrm flipV="1">
              <a:off x="1666460" y="833049"/>
              <a:ext cx="7680960" cy="0"/>
            </a:xfrm>
            <a:prstGeom prst="line">
              <a:avLst/>
            </a:prstGeom>
            <a:ln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00" name="TextBox 99"/>
            <p:cNvSpPr txBox="1"/>
            <p:nvPr/>
          </p:nvSpPr>
          <p:spPr>
            <a:xfrm>
              <a:off x="2725198" y="1223790"/>
              <a:ext cx="923197" cy="69250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r>
                <a:rPr lang="en-US" sz="450" i="1" dirty="0"/>
                <a:t>P. </a:t>
              </a:r>
              <a:r>
                <a:rPr lang="en-US" sz="450" i="1" dirty="0" err="1"/>
                <a:t>brachystachys</a:t>
              </a:r>
              <a:r>
                <a:rPr lang="en-US" sz="450" i="1" dirty="0"/>
                <a:t> </a:t>
              </a:r>
              <a:r>
                <a:rPr lang="en-US" sz="450" dirty="0"/>
                <a:t>(MN811180.1) </a:t>
              </a:r>
            </a:p>
          </p:txBody>
        </p:sp>
        <p:sp>
          <p:nvSpPr>
            <p:cNvPr id="101" name="TextBox 100"/>
            <p:cNvSpPr txBox="1"/>
            <p:nvPr/>
          </p:nvSpPr>
          <p:spPr>
            <a:xfrm>
              <a:off x="2723734" y="1286846"/>
              <a:ext cx="923197" cy="69250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r>
                <a:rPr lang="en-US" sz="450" i="1" dirty="0"/>
                <a:t>P. </a:t>
              </a:r>
              <a:r>
                <a:rPr lang="en-US" sz="450" i="1" dirty="0" err="1"/>
                <a:t>brachystachys</a:t>
              </a:r>
              <a:r>
                <a:rPr lang="en-US" sz="450" i="1" dirty="0"/>
                <a:t> </a:t>
              </a:r>
              <a:r>
                <a:rPr lang="en-US" sz="450" dirty="0"/>
                <a:t>(MN811178.1) </a:t>
              </a:r>
            </a:p>
          </p:txBody>
        </p:sp>
        <p:sp>
          <p:nvSpPr>
            <p:cNvPr id="102" name="TextBox 101"/>
            <p:cNvSpPr txBox="1"/>
            <p:nvPr/>
          </p:nvSpPr>
          <p:spPr>
            <a:xfrm>
              <a:off x="2724466" y="1341705"/>
              <a:ext cx="923197" cy="69250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r>
                <a:rPr lang="en-US" sz="450" i="1" dirty="0"/>
                <a:t>P. </a:t>
              </a:r>
              <a:r>
                <a:rPr lang="en-US" sz="450" i="1" dirty="0" err="1"/>
                <a:t>brachystachys</a:t>
              </a:r>
              <a:r>
                <a:rPr lang="en-US" sz="450" i="1" dirty="0"/>
                <a:t> </a:t>
              </a:r>
              <a:r>
                <a:rPr lang="en-US" sz="450" dirty="0"/>
                <a:t>(MN811179.1) </a:t>
              </a:r>
            </a:p>
          </p:txBody>
        </p:sp>
        <p:sp>
          <p:nvSpPr>
            <p:cNvPr id="103" name="TextBox 102"/>
            <p:cNvSpPr txBox="1"/>
            <p:nvPr/>
          </p:nvSpPr>
          <p:spPr>
            <a:xfrm>
              <a:off x="2724465" y="1396321"/>
              <a:ext cx="923197" cy="69250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r>
                <a:rPr lang="en-US" sz="450" i="1" dirty="0"/>
                <a:t>P. </a:t>
              </a:r>
              <a:r>
                <a:rPr lang="en-US" sz="450" i="1" dirty="0" err="1"/>
                <a:t>brachystachys</a:t>
              </a:r>
              <a:r>
                <a:rPr lang="en-US" sz="450" i="1" dirty="0"/>
                <a:t> </a:t>
              </a:r>
              <a:r>
                <a:rPr lang="en-US" sz="450" dirty="0"/>
                <a:t>(MN811181.1) </a:t>
              </a:r>
            </a:p>
          </p:txBody>
        </p:sp>
        <p:sp>
          <p:nvSpPr>
            <p:cNvPr id="105" name="TextBox 104"/>
            <p:cNvSpPr txBox="1"/>
            <p:nvPr/>
          </p:nvSpPr>
          <p:spPr>
            <a:xfrm>
              <a:off x="2723879" y="1450108"/>
              <a:ext cx="876063" cy="69250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r>
                <a:rPr lang="en-US" sz="450" i="1" dirty="0"/>
                <a:t>P. </a:t>
              </a:r>
              <a:r>
                <a:rPr lang="en-US" sz="450" i="1" dirty="0" err="1"/>
                <a:t>canariensis</a:t>
              </a:r>
              <a:r>
                <a:rPr lang="en-US" sz="450" i="1" dirty="0"/>
                <a:t> </a:t>
              </a:r>
              <a:r>
                <a:rPr lang="en-US" sz="450" dirty="0"/>
                <a:t>(MN811183.1) </a:t>
              </a:r>
            </a:p>
          </p:txBody>
        </p:sp>
        <p:sp>
          <p:nvSpPr>
            <p:cNvPr id="106" name="TextBox 105"/>
            <p:cNvSpPr txBox="1"/>
            <p:nvPr/>
          </p:nvSpPr>
          <p:spPr>
            <a:xfrm>
              <a:off x="2727153" y="1503904"/>
              <a:ext cx="876063" cy="69250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r>
                <a:rPr lang="en-US" sz="450" i="1" dirty="0"/>
                <a:t>P. </a:t>
              </a:r>
              <a:r>
                <a:rPr lang="en-US" sz="450" i="1" dirty="0" err="1"/>
                <a:t>canariensis</a:t>
              </a:r>
              <a:r>
                <a:rPr lang="en-US" sz="450" i="1" dirty="0"/>
                <a:t> </a:t>
              </a:r>
              <a:r>
                <a:rPr lang="en-US" sz="450" dirty="0"/>
                <a:t>(MN811184.1) </a:t>
              </a:r>
            </a:p>
          </p:txBody>
        </p:sp>
        <p:sp>
          <p:nvSpPr>
            <p:cNvPr id="107" name="TextBox 106"/>
            <p:cNvSpPr txBox="1"/>
            <p:nvPr/>
          </p:nvSpPr>
          <p:spPr>
            <a:xfrm>
              <a:off x="2727152" y="1563900"/>
              <a:ext cx="876063" cy="69250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r>
                <a:rPr lang="en-US" sz="450" i="1" dirty="0"/>
                <a:t>P. </a:t>
              </a:r>
              <a:r>
                <a:rPr lang="en-US" sz="450" i="1" dirty="0" err="1"/>
                <a:t>canariensis</a:t>
              </a:r>
              <a:r>
                <a:rPr lang="en-US" sz="450" i="1" dirty="0"/>
                <a:t> </a:t>
              </a:r>
              <a:r>
                <a:rPr lang="en-US" sz="450" dirty="0"/>
                <a:t>(MN811185.1) </a:t>
              </a:r>
            </a:p>
          </p:txBody>
        </p:sp>
        <p:sp>
          <p:nvSpPr>
            <p:cNvPr id="108" name="TextBox 107"/>
            <p:cNvSpPr txBox="1"/>
            <p:nvPr/>
          </p:nvSpPr>
          <p:spPr>
            <a:xfrm>
              <a:off x="2725198" y="1740077"/>
              <a:ext cx="853348" cy="69250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r>
                <a:rPr lang="en-US" sz="450" i="1" dirty="0">
                  <a:solidFill>
                    <a:srgbClr val="FF0000"/>
                  </a:solidFill>
                </a:rPr>
                <a:t>P. angusta </a:t>
              </a:r>
              <a:r>
                <a:rPr lang="en-US" sz="450" dirty="0">
                  <a:solidFill>
                    <a:srgbClr val="FF0000"/>
                  </a:solidFill>
                </a:rPr>
                <a:t>(KX873129.1) </a:t>
              </a:r>
            </a:p>
          </p:txBody>
        </p:sp>
        <p:sp>
          <p:nvSpPr>
            <p:cNvPr id="109" name="TextBox 108"/>
            <p:cNvSpPr txBox="1"/>
            <p:nvPr/>
          </p:nvSpPr>
          <p:spPr>
            <a:xfrm>
              <a:off x="2715807" y="2026367"/>
              <a:ext cx="853348" cy="69250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r>
                <a:rPr lang="en-US" sz="450" i="1" dirty="0"/>
                <a:t>P. aquatica </a:t>
              </a:r>
              <a:r>
                <a:rPr lang="en-US" sz="450" dirty="0"/>
                <a:t>(MN811173.1) </a:t>
              </a:r>
            </a:p>
          </p:txBody>
        </p:sp>
        <p:sp>
          <p:nvSpPr>
            <p:cNvPr id="110" name="TextBox 109"/>
            <p:cNvSpPr txBox="1"/>
            <p:nvPr/>
          </p:nvSpPr>
          <p:spPr>
            <a:xfrm>
              <a:off x="2717912" y="2084892"/>
              <a:ext cx="853348" cy="69250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r>
                <a:rPr lang="en-US" sz="450" i="1" dirty="0"/>
                <a:t>P. aquatica </a:t>
              </a:r>
              <a:r>
                <a:rPr lang="en-US" sz="450" dirty="0"/>
                <a:t>(MN811177.1) </a:t>
              </a:r>
            </a:p>
          </p:txBody>
        </p:sp>
        <p:sp>
          <p:nvSpPr>
            <p:cNvPr id="111" name="TextBox 110"/>
            <p:cNvSpPr txBox="1"/>
            <p:nvPr/>
          </p:nvSpPr>
          <p:spPr>
            <a:xfrm>
              <a:off x="2715807" y="2191671"/>
              <a:ext cx="853348" cy="69250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r>
                <a:rPr lang="en-US" sz="450" i="1" dirty="0"/>
                <a:t>P. aquatica </a:t>
              </a:r>
              <a:r>
                <a:rPr lang="en-US" sz="450" dirty="0"/>
                <a:t>(MN811172.1) </a:t>
              </a:r>
            </a:p>
          </p:txBody>
        </p:sp>
        <p:sp>
          <p:nvSpPr>
            <p:cNvPr id="112" name="TextBox 111"/>
            <p:cNvSpPr txBox="1"/>
            <p:nvPr/>
          </p:nvSpPr>
          <p:spPr>
            <a:xfrm>
              <a:off x="2717912" y="2301545"/>
              <a:ext cx="853348" cy="69250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r>
                <a:rPr lang="en-US" sz="450" i="1" dirty="0"/>
                <a:t>P. aquatica </a:t>
              </a:r>
              <a:r>
                <a:rPr lang="en-US" sz="450" dirty="0"/>
                <a:t>(MN811170.1) </a:t>
              </a:r>
            </a:p>
          </p:txBody>
        </p:sp>
        <p:sp>
          <p:nvSpPr>
            <p:cNvPr id="113" name="TextBox 112"/>
            <p:cNvSpPr txBox="1"/>
            <p:nvPr/>
          </p:nvSpPr>
          <p:spPr>
            <a:xfrm>
              <a:off x="2716749" y="2536809"/>
              <a:ext cx="760658" cy="69250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r>
                <a:rPr lang="en-US" sz="450" i="1" dirty="0"/>
                <a:t>P. </a:t>
              </a:r>
              <a:r>
                <a:rPr lang="en-US" sz="450" i="1" dirty="0" err="1"/>
                <a:t>coerulescens</a:t>
              </a:r>
              <a:r>
                <a:rPr lang="en-US" sz="450" i="1" dirty="0"/>
                <a:t> </a:t>
              </a:r>
              <a:r>
                <a:rPr lang="en-US" sz="450" dirty="0"/>
                <a:t>(MN811189.1) </a:t>
              </a:r>
            </a:p>
          </p:txBody>
        </p:sp>
        <p:sp>
          <p:nvSpPr>
            <p:cNvPr id="114" name="TextBox 113"/>
            <p:cNvSpPr txBox="1"/>
            <p:nvPr/>
          </p:nvSpPr>
          <p:spPr>
            <a:xfrm>
              <a:off x="2726196" y="2877410"/>
              <a:ext cx="760658" cy="69250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r>
                <a:rPr lang="en-US" sz="450" i="1" dirty="0">
                  <a:solidFill>
                    <a:srgbClr val="00B050"/>
                  </a:solidFill>
                </a:rPr>
                <a:t>P. </a:t>
              </a:r>
              <a:r>
                <a:rPr lang="en-US" sz="450" i="1" dirty="0" err="1">
                  <a:solidFill>
                    <a:srgbClr val="00B050"/>
                  </a:solidFill>
                </a:rPr>
                <a:t>coerulescens</a:t>
              </a:r>
              <a:r>
                <a:rPr lang="en-US" sz="450" i="1" dirty="0">
                  <a:solidFill>
                    <a:srgbClr val="00B050"/>
                  </a:solidFill>
                </a:rPr>
                <a:t> </a:t>
              </a:r>
              <a:r>
                <a:rPr lang="en-US" sz="450" dirty="0">
                  <a:solidFill>
                    <a:srgbClr val="00B050"/>
                  </a:solidFill>
                </a:rPr>
                <a:t>(MN811190.1) </a:t>
              </a:r>
            </a:p>
          </p:txBody>
        </p:sp>
        <p:sp>
          <p:nvSpPr>
            <p:cNvPr id="115" name="TextBox 114"/>
            <p:cNvSpPr txBox="1"/>
            <p:nvPr/>
          </p:nvSpPr>
          <p:spPr>
            <a:xfrm>
              <a:off x="2724340" y="3391382"/>
              <a:ext cx="870001" cy="69250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r>
                <a:rPr lang="en-US" sz="450" i="1" dirty="0"/>
                <a:t>P. </a:t>
              </a:r>
              <a:r>
                <a:rPr lang="en-US" sz="450" i="1" dirty="0" err="1"/>
                <a:t>paradoxa</a:t>
              </a:r>
              <a:r>
                <a:rPr lang="en-US" sz="450" i="1" dirty="0"/>
                <a:t> </a:t>
              </a:r>
              <a:r>
                <a:rPr lang="en-US" sz="450" dirty="0"/>
                <a:t>(MN811195.1) </a:t>
              </a:r>
            </a:p>
          </p:txBody>
        </p:sp>
        <p:sp>
          <p:nvSpPr>
            <p:cNvPr id="116" name="TextBox 115"/>
            <p:cNvSpPr txBox="1"/>
            <p:nvPr/>
          </p:nvSpPr>
          <p:spPr>
            <a:xfrm>
              <a:off x="2723527" y="3448594"/>
              <a:ext cx="870001" cy="69250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r>
                <a:rPr lang="en-US" sz="450" i="1" dirty="0"/>
                <a:t>P. </a:t>
              </a:r>
              <a:r>
                <a:rPr lang="en-US" sz="450" i="1" dirty="0" err="1"/>
                <a:t>paradoxa</a:t>
              </a:r>
              <a:r>
                <a:rPr lang="en-US" sz="450" i="1" dirty="0"/>
                <a:t> </a:t>
              </a:r>
              <a:r>
                <a:rPr lang="en-US" sz="450" dirty="0"/>
                <a:t>(MN811194.1) </a:t>
              </a:r>
            </a:p>
          </p:txBody>
        </p:sp>
        <p:sp>
          <p:nvSpPr>
            <p:cNvPr id="117" name="TextBox 116"/>
            <p:cNvSpPr txBox="1"/>
            <p:nvPr/>
          </p:nvSpPr>
          <p:spPr>
            <a:xfrm>
              <a:off x="2715807" y="5903409"/>
              <a:ext cx="688515" cy="69250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r>
                <a:rPr lang="en-US" sz="450" i="1" dirty="0"/>
                <a:t>P. </a:t>
              </a:r>
              <a:r>
                <a:rPr lang="en-US" sz="450" i="1" dirty="0" err="1"/>
                <a:t>lemmonii</a:t>
              </a:r>
              <a:r>
                <a:rPr lang="en-US" sz="450" i="1" dirty="0"/>
                <a:t> </a:t>
              </a:r>
              <a:r>
                <a:rPr lang="en-US" sz="450" dirty="0"/>
                <a:t>(MN811191.1) </a:t>
              </a:r>
            </a:p>
          </p:txBody>
        </p:sp>
        <p:sp>
          <p:nvSpPr>
            <p:cNvPr id="118" name="TextBox 117"/>
            <p:cNvSpPr txBox="1"/>
            <p:nvPr/>
          </p:nvSpPr>
          <p:spPr>
            <a:xfrm>
              <a:off x="2718570" y="6068314"/>
              <a:ext cx="688515" cy="69250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r>
                <a:rPr lang="en-US" sz="450" i="1" dirty="0"/>
                <a:t>P. </a:t>
              </a:r>
              <a:r>
                <a:rPr lang="en-US" sz="450" i="1" dirty="0" err="1"/>
                <a:t>lemmonii</a:t>
              </a:r>
              <a:r>
                <a:rPr lang="en-US" sz="450" i="1" dirty="0"/>
                <a:t> </a:t>
              </a:r>
              <a:r>
                <a:rPr lang="en-US" sz="450" dirty="0"/>
                <a:t>(MN811192.1) </a:t>
              </a:r>
            </a:p>
          </p:txBody>
        </p:sp>
        <p:sp>
          <p:nvSpPr>
            <p:cNvPr id="119" name="TextBox 118"/>
            <p:cNvSpPr txBox="1"/>
            <p:nvPr/>
          </p:nvSpPr>
          <p:spPr>
            <a:xfrm>
              <a:off x="2720794" y="4586183"/>
              <a:ext cx="737614" cy="69250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r>
                <a:rPr lang="en-US" sz="450" i="1" dirty="0"/>
                <a:t>P. </a:t>
              </a:r>
              <a:r>
                <a:rPr lang="en-US" sz="450" i="1" dirty="0" err="1"/>
                <a:t>arundinacea</a:t>
              </a:r>
              <a:r>
                <a:rPr lang="en-US" sz="450" i="1" dirty="0"/>
                <a:t> </a:t>
              </a:r>
              <a:r>
                <a:rPr lang="en-US" sz="450" dirty="0"/>
                <a:t>(MN811175.1) </a:t>
              </a:r>
            </a:p>
          </p:txBody>
        </p:sp>
        <p:sp>
          <p:nvSpPr>
            <p:cNvPr id="120" name="TextBox 119"/>
            <p:cNvSpPr txBox="1"/>
            <p:nvPr/>
          </p:nvSpPr>
          <p:spPr>
            <a:xfrm>
              <a:off x="2719941" y="4644232"/>
              <a:ext cx="737614" cy="69250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r>
                <a:rPr lang="en-US" sz="450" i="1" dirty="0"/>
                <a:t>P. </a:t>
              </a:r>
              <a:r>
                <a:rPr lang="en-US" sz="450" i="1" dirty="0" err="1"/>
                <a:t>arundinacea</a:t>
              </a:r>
              <a:r>
                <a:rPr lang="en-US" sz="450" i="1" dirty="0"/>
                <a:t> </a:t>
              </a:r>
              <a:r>
                <a:rPr lang="en-US" sz="450" dirty="0"/>
                <a:t>(MN811174.1) </a:t>
              </a:r>
            </a:p>
          </p:txBody>
        </p:sp>
        <p:sp>
          <p:nvSpPr>
            <p:cNvPr id="121" name="TextBox 120"/>
            <p:cNvSpPr txBox="1"/>
            <p:nvPr/>
          </p:nvSpPr>
          <p:spPr>
            <a:xfrm>
              <a:off x="2718570" y="4706514"/>
              <a:ext cx="737614" cy="69250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r>
                <a:rPr lang="en-US" sz="450" i="1" dirty="0"/>
                <a:t>P. </a:t>
              </a:r>
              <a:r>
                <a:rPr lang="en-US" sz="450" i="1" dirty="0" err="1"/>
                <a:t>arundinacea</a:t>
              </a:r>
              <a:r>
                <a:rPr lang="en-US" sz="450" i="1" dirty="0"/>
                <a:t> </a:t>
              </a:r>
              <a:r>
                <a:rPr lang="en-US" sz="450" dirty="0"/>
                <a:t>(MN811200.1) </a:t>
              </a:r>
            </a:p>
          </p:txBody>
        </p:sp>
        <p:sp>
          <p:nvSpPr>
            <p:cNvPr id="122" name="TextBox 121"/>
            <p:cNvSpPr txBox="1"/>
            <p:nvPr/>
          </p:nvSpPr>
          <p:spPr>
            <a:xfrm>
              <a:off x="2724202" y="4763404"/>
              <a:ext cx="737614" cy="69250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r>
                <a:rPr lang="en-US" sz="450" i="1" dirty="0"/>
                <a:t>P. </a:t>
              </a:r>
              <a:r>
                <a:rPr lang="en-US" sz="450" i="1" dirty="0" err="1"/>
                <a:t>arundinacea</a:t>
              </a:r>
              <a:r>
                <a:rPr lang="en-US" sz="450" i="1" dirty="0"/>
                <a:t> </a:t>
              </a:r>
              <a:r>
                <a:rPr lang="en-US" sz="450" dirty="0"/>
                <a:t>(MN811176.1) </a:t>
              </a:r>
            </a:p>
          </p:txBody>
        </p:sp>
        <p:sp>
          <p:nvSpPr>
            <p:cNvPr id="123" name="TextBox 122"/>
            <p:cNvSpPr txBox="1"/>
            <p:nvPr/>
          </p:nvSpPr>
          <p:spPr>
            <a:xfrm>
              <a:off x="2723328" y="5158879"/>
              <a:ext cx="688516" cy="69250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r>
                <a:rPr lang="en-US" sz="450" i="1" dirty="0"/>
                <a:t>P. </a:t>
              </a:r>
              <a:r>
                <a:rPr lang="en-US" sz="450" i="1" dirty="0" err="1"/>
                <a:t>californica</a:t>
              </a:r>
              <a:r>
                <a:rPr lang="en-US" sz="450" i="1" dirty="0"/>
                <a:t> </a:t>
              </a:r>
              <a:r>
                <a:rPr lang="en-US" sz="450" dirty="0"/>
                <a:t>(MN811182.1) </a:t>
              </a:r>
            </a:p>
          </p:txBody>
        </p:sp>
        <p:sp>
          <p:nvSpPr>
            <p:cNvPr id="124" name="TextBox 123"/>
            <p:cNvSpPr txBox="1"/>
            <p:nvPr/>
          </p:nvSpPr>
          <p:spPr>
            <a:xfrm>
              <a:off x="2712180" y="5841893"/>
              <a:ext cx="688515" cy="69250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r>
                <a:rPr lang="en-US" sz="450" i="1" dirty="0"/>
                <a:t>P. angusta </a:t>
              </a:r>
              <a:r>
                <a:rPr lang="en-US" sz="450" dirty="0"/>
                <a:t>(JF951054.1) </a:t>
              </a:r>
            </a:p>
          </p:txBody>
        </p:sp>
        <p:sp>
          <p:nvSpPr>
            <p:cNvPr id="125" name="TextBox 124"/>
            <p:cNvSpPr txBox="1"/>
            <p:nvPr/>
          </p:nvSpPr>
          <p:spPr>
            <a:xfrm>
              <a:off x="2712180" y="5731808"/>
              <a:ext cx="688515" cy="69250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r>
                <a:rPr lang="en-US" sz="450" i="1" dirty="0"/>
                <a:t>P. angusta </a:t>
              </a:r>
              <a:r>
                <a:rPr lang="en-US" sz="450" dirty="0"/>
                <a:t>(JF951055.1) </a:t>
              </a:r>
            </a:p>
          </p:txBody>
        </p:sp>
        <p:sp>
          <p:nvSpPr>
            <p:cNvPr id="126" name="TextBox 125"/>
            <p:cNvSpPr txBox="1"/>
            <p:nvPr/>
          </p:nvSpPr>
          <p:spPr>
            <a:xfrm>
              <a:off x="2713164" y="5675351"/>
              <a:ext cx="688515" cy="69250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r>
                <a:rPr lang="en-US" sz="450" i="1" dirty="0"/>
                <a:t>P. angusta </a:t>
              </a:r>
              <a:r>
                <a:rPr lang="en-US" sz="450" dirty="0"/>
                <a:t>(KF7553774.1) </a:t>
              </a:r>
            </a:p>
          </p:txBody>
        </p:sp>
        <p:sp>
          <p:nvSpPr>
            <p:cNvPr id="128" name="TextBox 127"/>
            <p:cNvSpPr txBox="1"/>
            <p:nvPr/>
          </p:nvSpPr>
          <p:spPr>
            <a:xfrm>
              <a:off x="2712180" y="6129684"/>
              <a:ext cx="688515" cy="69250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r>
                <a:rPr lang="en-US" sz="450" i="1" dirty="0"/>
                <a:t>P. </a:t>
              </a:r>
              <a:r>
                <a:rPr lang="en-US" sz="450" i="1" dirty="0" err="1"/>
                <a:t>angusta</a:t>
              </a:r>
              <a:r>
                <a:rPr lang="en-US" sz="450" i="1" dirty="0"/>
                <a:t> </a:t>
              </a:r>
              <a:r>
                <a:rPr lang="en-US" sz="450" dirty="0"/>
                <a:t>(MN811165.1) </a:t>
              </a:r>
            </a:p>
          </p:txBody>
        </p:sp>
        <p:sp>
          <p:nvSpPr>
            <p:cNvPr id="129" name="TextBox 128"/>
            <p:cNvSpPr txBox="1"/>
            <p:nvPr/>
          </p:nvSpPr>
          <p:spPr>
            <a:xfrm>
              <a:off x="2716087" y="6185100"/>
              <a:ext cx="688515" cy="69250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r>
                <a:rPr lang="en-US" sz="450" i="1" dirty="0"/>
                <a:t>P. </a:t>
              </a:r>
              <a:r>
                <a:rPr lang="en-US" sz="450" i="1" dirty="0" err="1"/>
                <a:t>angusta</a:t>
              </a:r>
              <a:r>
                <a:rPr lang="en-US" sz="450" i="1" dirty="0"/>
                <a:t> </a:t>
              </a:r>
              <a:r>
                <a:rPr lang="en-US" sz="450" dirty="0"/>
                <a:t>(MN811167.1) </a:t>
              </a:r>
            </a:p>
          </p:txBody>
        </p:sp>
        <p:sp>
          <p:nvSpPr>
            <p:cNvPr id="130" name="TextBox 129"/>
            <p:cNvSpPr txBox="1"/>
            <p:nvPr/>
          </p:nvSpPr>
          <p:spPr>
            <a:xfrm>
              <a:off x="2712179" y="6241131"/>
              <a:ext cx="688515" cy="69250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r>
                <a:rPr lang="en-US" sz="450" i="1" dirty="0"/>
                <a:t>P. </a:t>
              </a:r>
              <a:r>
                <a:rPr lang="en-US" sz="450" i="1" dirty="0" err="1"/>
                <a:t>angusta</a:t>
              </a:r>
              <a:r>
                <a:rPr lang="en-US" sz="450" i="1" dirty="0"/>
                <a:t> </a:t>
              </a:r>
              <a:r>
                <a:rPr lang="en-US" sz="450" dirty="0"/>
                <a:t>(MN811169.1) </a:t>
              </a:r>
            </a:p>
          </p:txBody>
        </p:sp>
        <p:sp>
          <p:nvSpPr>
            <p:cNvPr id="131" name="TextBox 130"/>
            <p:cNvSpPr txBox="1"/>
            <p:nvPr/>
          </p:nvSpPr>
          <p:spPr>
            <a:xfrm>
              <a:off x="2716401" y="6303331"/>
              <a:ext cx="688515" cy="69250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r>
                <a:rPr lang="en-US" sz="450" i="1" dirty="0">
                  <a:solidFill>
                    <a:srgbClr val="00B050"/>
                  </a:solidFill>
                </a:rPr>
                <a:t>P. aquatica </a:t>
              </a:r>
              <a:r>
                <a:rPr lang="en-US" sz="450" dirty="0">
                  <a:solidFill>
                    <a:srgbClr val="00B050"/>
                  </a:solidFill>
                </a:rPr>
                <a:t>(MN811171.1) </a:t>
              </a:r>
            </a:p>
          </p:txBody>
        </p:sp>
        <p:sp>
          <p:nvSpPr>
            <p:cNvPr id="132" name="TextBox 131"/>
            <p:cNvSpPr txBox="1"/>
            <p:nvPr/>
          </p:nvSpPr>
          <p:spPr>
            <a:xfrm>
              <a:off x="2718569" y="5277284"/>
              <a:ext cx="688515" cy="69250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r>
                <a:rPr lang="en-US" sz="450" i="1" dirty="0">
                  <a:solidFill>
                    <a:srgbClr val="00B050"/>
                  </a:solidFill>
                </a:rPr>
                <a:t>P. </a:t>
              </a:r>
              <a:r>
                <a:rPr lang="en-US" sz="450" i="1" dirty="0" err="1">
                  <a:solidFill>
                    <a:srgbClr val="00B050"/>
                  </a:solidFill>
                </a:rPr>
                <a:t>angusta</a:t>
              </a:r>
              <a:r>
                <a:rPr lang="en-US" sz="450" i="1" dirty="0">
                  <a:solidFill>
                    <a:srgbClr val="00B050"/>
                  </a:solidFill>
                </a:rPr>
                <a:t> </a:t>
              </a:r>
              <a:r>
                <a:rPr lang="en-US" sz="450" dirty="0">
                  <a:solidFill>
                    <a:srgbClr val="00B050"/>
                  </a:solidFill>
                </a:rPr>
                <a:t>(MN811166.1) </a:t>
              </a:r>
            </a:p>
          </p:txBody>
        </p:sp>
        <p:sp>
          <p:nvSpPr>
            <p:cNvPr id="133" name="TextBox 132"/>
            <p:cNvSpPr txBox="1"/>
            <p:nvPr/>
          </p:nvSpPr>
          <p:spPr>
            <a:xfrm>
              <a:off x="2721321" y="5786562"/>
              <a:ext cx="688515" cy="69250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r>
                <a:rPr lang="en-US" sz="450" i="1" dirty="0"/>
                <a:t>P. </a:t>
              </a:r>
              <a:r>
                <a:rPr lang="en-US" sz="450" i="1" dirty="0" err="1"/>
                <a:t>angusta</a:t>
              </a:r>
              <a:r>
                <a:rPr lang="en-US" sz="450" i="1" dirty="0"/>
                <a:t> </a:t>
              </a:r>
              <a:r>
                <a:rPr lang="en-US" sz="450" dirty="0"/>
                <a:t>(MN811168.1) </a:t>
              </a:r>
            </a:p>
          </p:txBody>
        </p:sp>
        <p:sp>
          <p:nvSpPr>
            <p:cNvPr id="136" name="TextBox 135"/>
            <p:cNvSpPr txBox="1"/>
            <p:nvPr/>
          </p:nvSpPr>
          <p:spPr>
            <a:xfrm>
              <a:off x="2712178" y="5333495"/>
              <a:ext cx="688515" cy="69250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r>
                <a:rPr lang="en-US" sz="450" i="1" dirty="0"/>
                <a:t>P. </a:t>
              </a:r>
              <a:r>
                <a:rPr lang="en-US" sz="450" i="1" dirty="0" err="1"/>
                <a:t>caroliniana</a:t>
              </a:r>
              <a:r>
                <a:rPr lang="en-US" sz="450" i="1" dirty="0"/>
                <a:t> </a:t>
              </a:r>
              <a:r>
                <a:rPr lang="en-US" sz="450" dirty="0"/>
                <a:t>(MN811187.1) </a:t>
              </a:r>
            </a:p>
          </p:txBody>
        </p:sp>
        <p:sp>
          <p:nvSpPr>
            <p:cNvPr id="137" name="TextBox 136"/>
            <p:cNvSpPr txBox="1"/>
            <p:nvPr/>
          </p:nvSpPr>
          <p:spPr>
            <a:xfrm>
              <a:off x="2718568" y="5388674"/>
              <a:ext cx="688515" cy="69250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r>
                <a:rPr lang="en-US" sz="450" i="1" dirty="0"/>
                <a:t>P. </a:t>
              </a:r>
              <a:r>
                <a:rPr lang="en-US" sz="450" i="1" dirty="0" err="1"/>
                <a:t>caroliniana</a:t>
              </a:r>
              <a:r>
                <a:rPr lang="en-US" sz="450" i="1" dirty="0"/>
                <a:t> </a:t>
              </a:r>
              <a:r>
                <a:rPr lang="en-US" sz="450" dirty="0"/>
                <a:t>(MN811188.1) </a:t>
              </a:r>
            </a:p>
          </p:txBody>
        </p:sp>
        <p:sp>
          <p:nvSpPr>
            <p:cNvPr id="138" name="TextBox 137"/>
            <p:cNvSpPr txBox="1"/>
            <p:nvPr/>
          </p:nvSpPr>
          <p:spPr>
            <a:xfrm>
              <a:off x="2714659" y="5443201"/>
              <a:ext cx="688515" cy="69250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r>
                <a:rPr lang="en-US" sz="450" i="1" dirty="0"/>
                <a:t>P. </a:t>
              </a:r>
              <a:r>
                <a:rPr lang="en-US" sz="450" i="1" dirty="0" err="1"/>
                <a:t>caroliniana</a:t>
              </a:r>
              <a:r>
                <a:rPr lang="en-US" sz="450" i="1" dirty="0"/>
                <a:t> </a:t>
              </a:r>
              <a:r>
                <a:rPr lang="en-US" sz="450" dirty="0"/>
                <a:t>(MN811186.1) </a:t>
              </a:r>
            </a:p>
          </p:txBody>
        </p:sp>
        <p:sp>
          <p:nvSpPr>
            <p:cNvPr id="140" name="TextBox 139"/>
            <p:cNvSpPr txBox="1"/>
            <p:nvPr/>
          </p:nvSpPr>
          <p:spPr>
            <a:xfrm>
              <a:off x="2724774" y="3216489"/>
              <a:ext cx="760658" cy="69250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r>
                <a:rPr lang="en-US" sz="450" i="1" dirty="0"/>
                <a:t>P. minor </a:t>
              </a:r>
              <a:r>
                <a:rPr lang="en-US" sz="450" dirty="0"/>
                <a:t>(KU883518.1) </a:t>
              </a:r>
            </a:p>
          </p:txBody>
        </p:sp>
        <p:cxnSp>
          <p:nvCxnSpPr>
            <p:cNvPr id="141" name="Straight Connector 140"/>
            <p:cNvCxnSpPr/>
            <p:nvPr/>
          </p:nvCxnSpPr>
          <p:spPr>
            <a:xfrm flipV="1">
              <a:off x="1661752" y="5626375"/>
              <a:ext cx="7680960" cy="0"/>
            </a:xfrm>
            <a:prstGeom prst="line">
              <a:avLst/>
            </a:prstGeom>
            <a:ln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50" name="Straight Connector 149"/>
            <p:cNvCxnSpPr/>
            <p:nvPr/>
          </p:nvCxnSpPr>
          <p:spPr>
            <a:xfrm flipV="1">
              <a:off x="1669020" y="5281362"/>
              <a:ext cx="7680960" cy="0"/>
            </a:xfrm>
            <a:prstGeom prst="line">
              <a:avLst/>
            </a:prstGeom>
            <a:ln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7" name="TextBox 6"/>
            <p:cNvSpPr txBox="1"/>
            <p:nvPr/>
          </p:nvSpPr>
          <p:spPr>
            <a:xfrm>
              <a:off x="2719032" y="4876088"/>
              <a:ext cx="858676" cy="69157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r>
                <a:rPr lang="en-US" sz="450" i="1" dirty="0"/>
                <a:t>P. arundinacea </a:t>
              </a:r>
              <a:r>
                <a:rPr lang="en-US" sz="450" dirty="0"/>
                <a:t>(KF713256.1) </a:t>
              </a:r>
            </a:p>
          </p:txBody>
        </p:sp>
        <p:sp>
          <p:nvSpPr>
            <p:cNvPr id="153" name="TextBox 152"/>
            <p:cNvSpPr txBox="1"/>
            <p:nvPr/>
          </p:nvSpPr>
          <p:spPr>
            <a:xfrm>
              <a:off x="3515541" y="668029"/>
              <a:ext cx="64329" cy="39234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endParaRPr lang="en-US" dirty="0"/>
            </a:p>
          </p:txBody>
        </p:sp>
        <p:sp>
          <p:nvSpPr>
            <p:cNvPr id="156" name="Rectangle 155"/>
            <p:cNvSpPr/>
            <p:nvPr/>
          </p:nvSpPr>
          <p:spPr>
            <a:xfrm>
              <a:off x="8628190" y="446637"/>
              <a:ext cx="9144" cy="378421"/>
            </a:xfrm>
            <a:prstGeom prst="rect">
              <a:avLst/>
            </a:prstGeom>
            <a:noFill/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57" name="TextBox 156"/>
            <p:cNvSpPr txBox="1"/>
            <p:nvPr/>
          </p:nvSpPr>
          <p:spPr>
            <a:xfrm>
              <a:off x="8647645" y="443014"/>
              <a:ext cx="95388" cy="107722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en-US" sz="700" dirty="0"/>
                <a:t>T5</a:t>
              </a:r>
              <a:endParaRPr lang="en-US" dirty="0"/>
            </a:p>
          </p:txBody>
        </p:sp>
        <p:sp>
          <p:nvSpPr>
            <p:cNvPr id="158" name="Rectangle 157"/>
            <p:cNvSpPr/>
            <p:nvPr/>
          </p:nvSpPr>
          <p:spPr>
            <a:xfrm>
              <a:off x="5823347" y="444280"/>
              <a:ext cx="9144" cy="378421"/>
            </a:xfrm>
            <a:prstGeom prst="rect">
              <a:avLst/>
            </a:prstGeom>
            <a:noFill/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59" name="TextBox 158"/>
            <p:cNvSpPr txBox="1"/>
            <p:nvPr/>
          </p:nvSpPr>
          <p:spPr>
            <a:xfrm>
              <a:off x="5842802" y="440657"/>
              <a:ext cx="95388" cy="107722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en-US" sz="700" dirty="0"/>
                <a:t>T3</a:t>
              </a:r>
              <a:endParaRPr lang="en-US" dirty="0"/>
            </a:p>
          </p:txBody>
        </p:sp>
        <p:sp>
          <p:nvSpPr>
            <p:cNvPr id="160" name="Rectangle 159"/>
            <p:cNvSpPr/>
            <p:nvPr/>
          </p:nvSpPr>
          <p:spPr>
            <a:xfrm>
              <a:off x="5681628" y="444525"/>
              <a:ext cx="9144" cy="378421"/>
            </a:xfrm>
            <a:prstGeom prst="rect">
              <a:avLst/>
            </a:prstGeom>
            <a:noFill/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61" name="TextBox 160"/>
            <p:cNvSpPr txBox="1"/>
            <p:nvPr/>
          </p:nvSpPr>
          <p:spPr>
            <a:xfrm>
              <a:off x="5580749" y="438799"/>
              <a:ext cx="95388" cy="107722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en-US" sz="700" dirty="0"/>
                <a:t>T2</a:t>
              </a:r>
              <a:endParaRPr lang="en-US" dirty="0"/>
            </a:p>
          </p:txBody>
        </p:sp>
        <p:sp>
          <p:nvSpPr>
            <p:cNvPr id="162" name="Rectangle 161"/>
            <p:cNvSpPr/>
            <p:nvPr/>
          </p:nvSpPr>
          <p:spPr>
            <a:xfrm>
              <a:off x="3953690" y="446548"/>
              <a:ext cx="9144" cy="378421"/>
            </a:xfrm>
            <a:prstGeom prst="rect">
              <a:avLst/>
            </a:prstGeom>
            <a:noFill/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63" name="TextBox 162"/>
            <p:cNvSpPr txBox="1"/>
            <p:nvPr/>
          </p:nvSpPr>
          <p:spPr>
            <a:xfrm>
              <a:off x="3852811" y="440822"/>
              <a:ext cx="95388" cy="107722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en-US" sz="700" dirty="0"/>
                <a:t>T1</a:t>
              </a:r>
              <a:endParaRPr lang="en-US" dirty="0"/>
            </a:p>
          </p:txBody>
        </p:sp>
        <p:sp>
          <p:nvSpPr>
            <p:cNvPr id="164" name="Rectangle 163"/>
            <p:cNvSpPr/>
            <p:nvPr/>
          </p:nvSpPr>
          <p:spPr>
            <a:xfrm>
              <a:off x="6857256" y="441609"/>
              <a:ext cx="9144" cy="378421"/>
            </a:xfrm>
            <a:prstGeom prst="rect">
              <a:avLst/>
            </a:prstGeom>
            <a:noFill/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grpSp>
          <p:nvGrpSpPr>
            <p:cNvPr id="168" name="Group 167"/>
            <p:cNvGrpSpPr/>
            <p:nvPr/>
          </p:nvGrpSpPr>
          <p:grpSpPr>
            <a:xfrm>
              <a:off x="8817445" y="3288932"/>
              <a:ext cx="110023" cy="618373"/>
              <a:chOff x="7534764" y="3503695"/>
              <a:chExt cx="110023" cy="618373"/>
            </a:xfrm>
          </p:grpSpPr>
          <p:sp>
            <p:nvSpPr>
              <p:cNvPr id="166" name="Rectangle 165"/>
              <p:cNvSpPr/>
              <p:nvPr/>
            </p:nvSpPr>
            <p:spPr>
              <a:xfrm>
                <a:off x="7635643" y="3509420"/>
                <a:ext cx="9144" cy="612648"/>
              </a:xfrm>
              <a:prstGeom prst="rect">
                <a:avLst/>
              </a:prstGeom>
              <a:noFill/>
              <a:ln w="31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167" name="TextBox 166"/>
              <p:cNvSpPr txBox="1"/>
              <p:nvPr/>
            </p:nvSpPr>
            <p:spPr>
              <a:xfrm>
                <a:off x="7534764" y="3503695"/>
                <a:ext cx="95388" cy="107722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lIns="0" tIns="0" rIns="0" bIns="0" rtlCol="0">
                <a:spAutoFit/>
              </a:bodyPr>
              <a:lstStyle/>
              <a:p>
                <a:pPr algn="ctr"/>
                <a:r>
                  <a:rPr lang="en-US" sz="700" dirty="0"/>
                  <a:t>P1</a:t>
                </a:r>
                <a:endParaRPr lang="en-US" dirty="0"/>
              </a:p>
            </p:txBody>
          </p:sp>
        </p:grpSp>
        <p:grpSp>
          <p:nvGrpSpPr>
            <p:cNvPr id="169" name="Group 168"/>
            <p:cNvGrpSpPr/>
            <p:nvPr/>
          </p:nvGrpSpPr>
          <p:grpSpPr>
            <a:xfrm>
              <a:off x="8927468" y="5064658"/>
              <a:ext cx="166502" cy="204035"/>
              <a:chOff x="7478285" y="3503695"/>
              <a:chExt cx="166502" cy="204035"/>
            </a:xfrm>
          </p:grpSpPr>
          <p:sp>
            <p:nvSpPr>
              <p:cNvPr id="170" name="Rectangle 169"/>
              <p:cNvSpPr/>
              <p:nvPr/>
            </p:nvSpPr>
            <p:spPr>
              <a:xfrm>
                <a:off x="7635643" y="3506562"/>
                <a:ext cx="9144" cy="201168"/>
              </a:xfrm>
              <a:prstGeom prst="rect">
                <a:avLst/>
              </a:prstGeom>
              <a:noFill/>
              <a:ln w="31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171" name="TextBox 170"/>
              <p:cNvSpPr txBox="1"/>
              <p:nvPr/>
            </p:nvSpPr>
            <p:spPr>
              <a:xfrm>
                <a:off x="7478285" y="3503695"/>
                <a:ext cx="151867" cy="107722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lIns="0" tIns="0" rIns="0" bIns="0" rtlCol="0">
                <a:spAutoFit/>
              </a:bodyPr>
              <a:lstStyle/>
              <a:p>
                <a:pPr algn="ctr"/>
                <a:r>
                  <a:rPr lang="en-US" sz="700" dirty="0"/>
                  <a:t>CA2</a:t>
                </a:r>
                <a:endParaRPr lang="en-US" dirty="0"/>
              </a:p>
            </p:txBody>
          </p:sp>
        </p:grpSp>
        <p:grpSp>
          <p:nvGrpSpPr>
            <p:cNvPr id="172" name="Group 171"/>
            <p:cNvGrpSpPr/>
            <p:nvPr/>
          </p:nvGrpSpPr>
          <p:grpSpPr>
            <a:xfrm>
              <a:off x="6864709" y="5063829"/>
              <a:ext cx="172746" cy="207227"/>
              <a:chOff x="7638501" y="3500503"/>
              <a:chExt cx="172746" cy="207227"/>
            </a:xfrm>
          </p:grpSpPr>
          <p:sp>
            <p:nvSpPr>
              <p:cNvPr id="173" name="Rectangle 172"/>
              <p:cNvSpPr/>
              <p:nvPr/>
            </p:nvSpPr>
            <p:spPr>
              <a:xfrm>
                <a:off x="7638501" y="3506562"/>
                <a:ext cx="9144" cy="201168"/>
              </a:xfrm>
              <a:prstGeom prst="rect">
                <a:avLst/>
              </a:prstGeom>
              <a:noFill/>
              <a:ln w="31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174" name="TextBox 173"/>
              <p:cNvSpPr txBox="1"/>
              <p:nvPr/>
            </p:nvSpPr>
            <p:spPr>
              <a:xfrm>
                <a:off x="7659380" y="3500503"/>
                <a:ext cx="151867" cy="107722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lIns="0" tIns="0" rIns="0" bIns="0" rtlCol="0">
                <a:spAutoFit/>
              </a:bodyPr>
              <a:lstStyle/>
              <a:p>
                <a:pPr algn="ctr"/>
                <a:r>
                  <a:rPr lang="en-US" sz="700" dirty="0"/>
                  <a:t>CA1</a:t>
                </a:r>
                <a:endParaRPr lang="en-US" dirty="0"/>
              </a:p>
            </p:txBody>
          </p:sp>
        </p:grpSp>
        <p:grpSp>
          <p:nvGrpSpPr>
            <p:cNvPr id="186" name="Group 185"/>
            <p:cNvGrpSpPr/>
            <p:nvPr/>
          </p:nvGrpSpPr>
          <p:grpSpPr>
            <a:xfrm>
              <a:off x="8472399" y="5340465"/>
              <a:ext cx="168490" cy="282784"/>
              <a:chOff x="7476297" y="3497399"/>
              <a:chExt cx="168490" cy="210331"/>
            </a:xfrm>
          </p:grpSpPr>
          <p:sp>
            <p:nvSpPr>
              <p:cNvPr id="187" name="Rectangle 186"/>
              <p:cNvSpPr/>
              <p:nvPr/>
            </p:nvSpPr>
            <p:spPr>
              <a:xfrm>
                <a:off x="7635643" y="3506562"/>
                <a:ext cx="9144" cy="201168"/>
              </a:xfrm>
              <a:prstGeom prst="rect">
                <a:avLst/>
              </a:prstGeom>
              <a:noFill/>
              <a:ln w="31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188" name="TextBox 187"/>
              <p:cNvSpPr txBox="1"/>
              <p:nvPr/>
            </p:nvSpPr>
            <p:spPr>
              <a:xfrm>
                <a:off x="7476297" y="3497399"/>
                <a:ext cx="153855" cy="80122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lIns="0" tIns="0" rIns="0" bIns="0" rtlCol="0">
                <a:spAutoFit/>
              </a:bodyPr>
              <a:lstStyle/>
              <a:p>
                <a:pPr algn="ctr"/>
                <a:r>
                  <a:rPr lang="en-US" sz="700" dirty="0"/>
                  <a:t>CR3</a:t>
                </a:r>
                <a:endParaRPr lang="en-US" dirty="0"/>
              </a:p>
            </p:txBody>
          </p:sp>
        </p:grpSp>
        <p:grpSp>
          <p:nvGrpSpPr>
            <p:cNvPr id="189" name="Group 188"/>
            <p:cNvGrpSpPr/>
            <p:nvPr/>
          </p:nvGrpSpPr>
          <p:grpSpPr>
            <a:xfrm>
              <a:off x="7218196" y="5339994"/>
              <a:ext cx="168490" cy="282784"/>
              <a:chOff x="7476297" y="3497399"/>
              <a:chExt cx="168490" cy="210331"/>
            </a:xfrm>
          </p:grpSpPr>
          <p:sp>
            <p:nvSpPr>
              <p:cNvPr id="190" name="Rectangle 189"/>
              <p:cNvSpPr/>
              <p:nvPr/>
            </p:nvSpPr>
            <p:spPr>
              <a:xfrm>
                <a:off x="7635643" y="3506562"/>
                <a:ext cx="9144" cy="201168"/>
              </a:xfrm>
              <a:prstGeom prst="rect">
                <a:avLst/>
              </a:prstGeom>
              <a:noFill/>
              <a:ln w="31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191" name="TextBox 190"/>
              <p:cNvSpPr txBox="1"/>
              <p:nvPr/>
            </p:nvSpPr>
            <p:spPr>
              <a:xfrm>
                <a:off x="7476297" y="3497399"/>
                <a:ext cx="153855" cy="80122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lIns="0" tIns="0" rIns="0" bIns="0" rtlCol="0">
                <a:spAutoFit/>
              </a:bodyPr>
              <a:lstStyle/>
              <a:p>
                <a:pPr algn="ctr"/>
                <a:r>
                  <a:rPr lang="en-US" sz="700" dirty="0"/>
                  <a:t>CR2</a:t>
                </a:r>
                <a:endParaRPr lang="en-US" dirty="0"/>
              </a:p>
            </p:txBody>
          </p:sp>
        </p:grpSp>
        <p:grpSp>
          <p:nvGrpSpPr>
            <p:cNvPr id="192" name="Group 191"/>
            <p:cNvGrpSpPr/>
            <p:nvPr/>
          </p:nvGrpSpPr>
          <p:grpSpPr>
            <a:xfrm>
              <a:off x="6277154" y="5330972"/>
              <a:ext cx="168490" cy="282784"/>
              <a:chOff x="7476297" y="3497399"/>
              <a:chExt cx="168490" cy="210331"/>
            </a:xfrm>
          </p:grpSpPr>
          <p:sp>
            <p:nvSpPr>
              <p:cNvPr id="193" name="Rectangle 192"/>
              <p:cNvSpPr/>
              <p:nvPr/>
            </p:nvSpPr>
            <p:spPr>
              <a:xfrm>
                <a:off x="7635643" y="3506562"/>
                <a:ext cx="9144" cy="201168"/>
              </a:xfrm>
              <a:prstGeom prst="rect">
                <a:avLst/>
              </a:prstGeom>
              <a:noFill/>
              <a:ln w="31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194" name="TextBox 193"/>
              <p:cNvSpPr txBox="1"/>
              <p:nvPr/>
            </p:nvSpPr>
            <p:spPr>
              <a:xfrm>
                <a:off x="7476297" y="3497399"/>
                <a:ext cx="153855" cy="80122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lIns="0" tIns="0" rIns="0" bIns="0" rtlCol="0">
                <a:spAutoFit/>
              </a:bodyPr>
              <a:lstStyle/>
              <a:p>
                <a:pPr algn="ctr"/>
                <a:r>
                  <a:rPr lang="en-US" sz="700" dirty="0"/>
                  <a:t>CR1</a:t>
                </a:r>
                <a:endParaRPr lang="en-US" dirty="0"/>
              </a:p>
            </p:txBody>
          </p:sp>
        </p:grpSp>
        <p:grpSp>
          <p:nvGrpSpPr>
            <p:cNvPr id="195" name="Group 194"/>
            <p:cNvGrpSpPr/>
            <p:nvPr/>
          </p:nvGrpSpPr>
          <p:grpSpPr>
            <a:xfrm>
              <a:off x="8355907" y="2780115"/>
              <a:ext cx="178553" cy="498264"/>
              <a:chOff x="7466234" y="3509420"/>
              <a:chExt cx="178553" cy="612648"/>
            </a:xfrm>
          </p:grpSpPr>
          <p:sp>
            <p:nvSpPr>
              <p:cNvPr id="196" name="Rectangle 195"/>
              <p:cNvSpPr/>
              <p:nvPr/>
            </p:nvSpPr>
            <p:spPr>
              <a:xfrm>
                <a:off x="7635643" y="3509420"/>
                <a:ext cx="9144" cy="612648"/>
              </a:xfrm>
              <a:prstGeom prst="rect">
                <a:avLst/>
              </a:prstGeom>
              <a:noFill/>
              <a:ln w="31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197" name="TextBox 196"/>
              <p:cNvSpPr txBox="1"/>
              <p:nvPr/>
            </p:nvSpPr>
            <p:spPr>
              <a:xfrm>
                <a:off x="7466234" y="3514105"/>
                <a:ext cx="163918" cy="132451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lIns="0" tIns="0" rIns="0" bIns="0" rtlCol="0">
                <a:spAutoFit/>
              </a:bodyPr>
              <a:lstStyle/>
              <a:p>
                <a:pPr algn="ctr"/>
                <a:r>
                  <a:rPr lang="en-US" sz="700" dirty="0"/>
                  <a:t>M3</a:t>
                </a:r>
                <a:endParaRPr lang="en-US" dirty="0"/>
              </a:p>
            </p:txBody>
          </p:sp>
        </p:grpSp>
        <p:grpSp>
          <p:nvGrpSpPr>
            <p:cNvPr id="198" name="Group 197"/>
            <p:cNvGrpSpPr/>
            <p:nvPr/>
          </p:nvGrpSpPr>
          <p:grpSpPr>
            <a:xfrm>
              <a:off x="6948387" y="2780098"/>
              <a:ext cx="151564" cy="498264"/>
              <a:chOff x="7635643" y="3509420"/>
              <a:chExt cx="151564" cy="612648"/>
            </a:xfrm>
          </p:grpSpPr>
          <p:sp>
            <p:nvSpPr>
              <p:cNvPr id="199" name="Rectangle 198"/>
              <p:cNvSpPr/>
              <p:nvPr/>
            </p:nvSpPr>
            <p:spPr>
              <a:xfrm>
                <a:off x="7635643" y="3509420"/>
                <a:ext cx="9144" cy="612648"/>
              </a:xfrm>
              <a:prstGeom prst="rect">
                <a:avLst/>
              </a:prstGeom>
              <a:noFill/>
              <a:ln w="31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200" name="TextBox 199"/>
              <p:cNvSpPr txBox="1"/>
              <p:nvPr/>
            </p:nvSpPr>
            <p:spPr>
              <a:xfrm>
                <a:off x="7661764" y="3514105"/>
                <a:ext cx="125443" cy="132451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lIns="0" tIns="0" rIns="0" bIns="0" rtlCol="0">
                <a:spAutoFit/>
              </a:bodyPr>
              <a:lstStyle/>
              <a:p>
                <a:pPr algn="ctr"/>
                <a:r>
                  <a:rPr lang="en-US" sz="700" dirty="0"/>
                  <a:t>M2</a:t>
                </a:r>
              </a:p>
            </p:txBody>
          </p:sp>
        </p:grpSp>
        <p:grpSp>
          <p:nvGrpSpPr>
            <p:cNvPr id="201" name="Group 200"/>
            <p:cNvGrpSpPr/>
            <p:nvPr/>
          </p:nvGrpSpPr>
          <p:grpSpPr>
            <a:xfrm>
              <a:off x="6294171" y="2775082"/>
              <a:ext cx="151564" cy="498264"/>
              <a:chOff x="7635643" y="3509420"/>
              <a:chExt cx="151564" cy="612648"/>
            </a:xfrm>
          </p:grpSpPr>
          <p:sp>
            <p:nvSpPr>
              <p:cNvPr id="202" name="Rectangle 201"/>
              <p:cNvSpPr/>
              <p:nvPr/>
            </p:nvSpPr>
            <p:spPr>
              <a:xfrm>
                <a:off x="7635643" y="3509420"/>
                <a:ext cx="9144" cy="612648"/>
              </a:xfrm>
              <a:prstGeom prst="rect">
                <a:avLst/>
              </a:prstGeom>
              <a:noFill/>
              <a:ln w="31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203" name="TextBox 202"/>
              <p:cNvSpPr txBox="1"/>
              <p:nvPr/>
            </p:nvSpPr>
            <p:spPr>
              <a:xfrm>
                <a:off x="7661764" y="3514105"/>
                <a:ext cx="125443" cy="132451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lIns="0" tIns="0" rIns="0" bIns="0" rtlCol="0">
                <a:spAutoFit/>
              </a:bodyPr>
              <a:lstStyle/>
              <a:p>
                <a:pPr algn="ctr"/>
                <a:r>
                  <a:rPr lang="en-US" sz="700" dirty="0"/>
                  <a:t>M1</a:t>
                </a:r>
              </a:p>
            </p:txBody>
          </p:sp>
        </p:grpSp>
        <p:grpSp>
          <p:nvGrpSpPr>
            <p:cNvPr id="204" name="Group 203"/>
            <p:cNvGrpSpPr/>
            <p:nvPr/>
          </p:nvGrpSpPr>
          <p:grpSpPr>
            <a:xfrm>
              <a:off x="9221848" y="2382332"/>
              <a:ext cx="193185" cy="379222"/>
              <a:chOff x="7644109" y="3504111"/>
              <a:chExt cx="193185" cy="466278"/>
            </a:xfrm>
          </p:grpSpPr>
          <p:sp>
            <p:nvSpPr>
              <p:cNvPr id="205" name="Rectangle 204"/>
              <p:cNvSpPr/>
              <p:nvPr/>
            </p:nvSpPr>
            <p:spPr>
              <a:xfrm>
                <a:off x="7644109" y="3509420"/>
                <a:ext cx="18288" cy="460969"/>
              </a:xfrm>
              <a:prstGeom prst="rect">
                <a:avLst/>
              </a:prstGeom>
              <a:noFill/>
              <a:ln w="31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206" name="TextBox 205"/>
              <p:cNvSpPr txBox="1"/>
              <p:nvPr/>
            </p:nvSpPr>
            <p:spPr>
              <a:xfrm>
                <a:off x="7673376" y="3504111"/>
                <a:ext cx="163918" cy="132451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lIns="0" tIns="0" rIns="0" bIns="0" rtlCol="0">
                <a:spAutoFit/>
              </a:bodyPr>
              <a:lstStyle/>
              <a:p>
                <a:pPr algn="ctr"/>
                <a:r>
                  <a:rPr lang="en-US" sz="700" dirty="0"/>
                  <a:t>C3</a:t>
                </a:r>
                <a:endParaRPr lang="en-US" dirty="0"/>
              </a:p>
            </p:txBody>
          </p:sp>
        </p:grpSp>
        <p:grpSp>
          <p:nvGrpSpPr>
            <p:cNvPr id="210" name="Group 209"/>
            <p:cNvGrpSpPr/>
            <p:nvPr/>
          </p:nvGrpSpPr>
          <p:grpSpPr>
            <a:xfrm>
              <a:off x="8871571" y="2391426"/>
              <a:ext cx="200688" cy="374990"/>
              <a:chOff x="7461709" y="3504111"/>
              <a:chExt cx="200688" cy="461074"/>
            </a:xfrm>
          </p:grpSpPr>
          <p:sp>
            <p:nvSpPr>
              <p:cNvPr id="211" name="Rectangle 210"/>
              <p:cNvSpPr/>
              <p:nvPr/>
            </p:nvSpPr>
            <p:spPr>
              <a:xfrm>
                <a:off x="7644109" y="3504216"/>
                <a:ext cx="18288" cy="460969"/>
              </a:xfrm>
              <a:prstGeom prst="rect">
                <a:avLst/>
              </a:prstGeom>
              <a:noFill/>
              <a:ln w="31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212" name="TextBox 211"/>
              <p:cNvSpPr txBox="1"/>
              <p:nvPr/>
            </p:nvSpPr>
            <p:spPr>
              <a:xfrm>
                <a:off x="7461709" y="3504111"/>
                <a:ext cx="163918" cy="132451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lIns="0" tIns="0" rIns="0" bIns="0" rtlCol="0">
                <a:spAutoFit/>
              </a:bodyPr>
              <a:lstStyle/>
              <a:p>
                <a:pPr algn="ctr"/>
                <a:r>
                  <a:rPr lang="en-US" sz="700" dirty="0"/>
                  <a:t>C1</a:t>
                </a:r>
                <a:endParaRPr lang="en-US" dirty="0"/>
              </a:p>
            </p:txBody>
          </p:sp>
        </p:grpSp>
        <p:grpSp>
          <p:nvGrpSpPr>
            <p:cNvPr id="207" name="Group 206"/>
            <p:cNvGrpSpPr/>
            <p:nvPr/>
          </p:nvGrpSpPr>
          <p:grpSpPr>
            <a:xfrm>
              <a:off x="9024506" y="2386652"/>
              <a:ext cx="183513" cy="374905"/>
              <a:chOff x="7478884" y="3504216"/>
              <a:chExt cx="183513" cy="460969"/>
            </a:xfrm>
          </p:grpSpPr>
          <p:sp>
            <p:nvSpPr>
              <p:cNvPr id="208" name="Rectangle 207"/>
              <p:cNvSpPr/>
              <p:nvPr/>
            </p:nvSpPr>
            <p:spPr>
              <a:xfrm>
                <a:off x="7644109" y="3504216"/>
                <a:ext cx="18288" cy="460969"/>
              </a:xfrm>
              <a:prstGeom prst="rect">
                <a:avLst/>
              </a:prstGeom>
              <a:noFill/>
              <a:ln w="31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209" name="TextBox 208"/>
              <p:cNvSpPr txBox="1"/>
              <p:nvPr/>
            </p:nvSpPr>
            <p:spPr>
              <a:xfrm>
                <a:off x="7478884" y="3810486"/>
                <a:ext cx="163918" cy="132451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lIns="0" tIns="0" rIns="0" bIns="0" rtlCol="0">
                <a:spAutoFit/>
              </a:bodyPr>
              <a:lstStyle/>
              <a:p>
                <a:pPr algn="ctr"/>
                <a:r>
                  <a:rPr lang="en-US" sz="700" dirty="0"/>
                  <a:t>C2</a:t>
                </a:r>
                <a:endParaRPr lang="en-US" dirty="0"/>
              </a:p>
            </p:txBody>
          </p:sp>
        </p:grpSp>
        <p:grpSp>
          <p:nvGrpSpPr>
            <p:cNvPr id="213" name="Group 212"/>
            <p:cNvGrpSpPr/>
            <p:nvPr/>
          </p:nvGrpSpPr>
          <p:grpSpPr>
            <a:xfrm>
              <a:off x="8415868" y="3924672"/>
              <a:ext cx="171894" cy="1124712"/>
              <a:chOff x="7472893" y="3509420"/>
              <a:chExt cx="171894" cy="1124712"/>
            </a:xfrm>
          </p:grpSpPr>
          <p:sp>
            <p:nvSpPr>
              <p:cNvPr id="214" name="Rectangle 213"/>
              <p:cNvSpPr/>
              <p:nvPr/>
            </p:nvSpPr>
            <p:spPr>
              <a:xfrm>
                <a:off x="7635643" y="3509420"/>
                <a:ext cx="9144" cy="1124712"/>
              </a:xfrm>
              <a:prstGeom prst="rect">
                <a:avLst/>
              </a:prstGeom>
              <a:noFill/>
              <a:ln w="31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215" name="TextBox 214"/>
              <p:cNvSpPr txBox="1"/>
              <p:nvPr/>
            </p:nvSpPr>
            <p:spPr>
              <a:xfrm>
                <a:off x="7472893" y="3515728"/>
                <a:ext cx="157259" cy="107722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lIns="0" tIns="0" rIns="0" bIns="0" rtlCol="0">
                <a:spAutoFit/>
              </a:bodyPr>
              <a:lstStyle/>
              <a:p>
                <a:pPr algn="ctr"/>
                <a:r>
                  <a:rPr lang="en-US" sz="700" dirty="0"/>
                  <a:t>AR6</a:t>
                </a:r>
                <a:endParaRPr lang="en-US" dirty="0"/>
              </a:p>
            </p:txBody>
          </p:sp>
        </p:grpSp>
        <p:grpSp>
          <p:nvGrpSpPr>
            <p:cNvPr id="216" name="Group 215"/>
            <p:cNvGrpSpPr/>
            <p:nvPr/>
          </p:nvGrpSpPr>
          <p:grpSpPr>
            <a:xfrm>
              <a:off x="8074670" y="3928160"/>
              <a:ext cx="171894" cy="1124712"/>
              <a:chOff x="7472893" y="3509420"/>
              <a:chExt cx="171894" cy="1124712"/>
            </a:xfrm>
          </p:grpSpPr>
          <p:sp>
            <p:nvSpPr>
              <p:cNvPr id="217" name="Rectangle 216"/>
              <p:cNvSpPr/>
              <p:nvPr/>
            </p:nvSpPr>
            <p:spPr>
              <a:xfrm>
                <a:off x="7635643" y="3509420"/>
                <a:ext cx="9144" cy="1124712"/>
              </a:xfrm>
              <a:prstGeom prst="rect">
                <a:avLst/>
              </a:prstGeom>
              <a:noFill/>
              <a:ln w="31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218" name="TextBox 217"/>
              <p:cNvSpPr txBox="1"/>
              <p:nvPr/>
            </p:nvSpPr>
            <p:spPr>
              <a:xfrm>
                <a:off x="7472893" y="3515728"/>
                <a:ext cx="157259" cy="107722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lIns="0" tIns="0" rIns="0" bIns="0" rtlCol="0">
                <a:spAutoFit/>
              </a:bodyPr>
              <a:lstStyle/>
              <a:p>
                <a:pPr algn="ctr"/>
                <a:r>
                  <a:rPr lang="en-US" sz="700" dirty="0"/>
                  <a:t>AR5</a:t>
                </a:r>
                <a:endParaRPr lang="en-US" dirty="0"/>
              </a:p>
            </p:txBody>
          </p:sp>
        </p:grpSp>
        <p:grpSp>
          <p:nvGrpSpPr>
            <p:cNvPr id="219" name="Group 218"/>
            <p:cNvGrpSpPr/>
            <p:nvPr/>
          </p:nvGrpSpPr>
          <p:grpSpPr>
            <a:xfrm>
              <a:off x="7159608" y="3923739"/>
              <a:ext cx="171894" cy="1124712"/>
              <a:chOff x="7472893" y="3509420"/>
              <a:chExt cx="171894" cy="1124712"/>
            </a:xfrm>
          </p:grpSpPr>
          <p:sp>
            <p:nvSpPr>
              <p:cNvPr id="220" name="Rectangle 219"/>
              <p:cNvSpPr/>
              <p:nvPr/>
            </p:nvSpPr>
            <p:spPr>
              <a:xfrm>
                <a:off x="7635643" y="3509420"/>
                <a:ext cx="9144" cy="1124712"/>
              </a:xfrm>
              <a:prstGeom prst="rect">
                <a:avLst/>
              </a:prstGeom>
              <a:noFill/>
              <a:ln w="31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221" name="TextBox 220"/>
              <p:cNvSpPr txBox="1"/>
              <p:nvPr/>
            </p:nvSpPr>
            <p:spPr>
              <a:xfrm>
                <a:off x="7472893" y="3515728"/>
                <a:ext cx="157259" cy="107722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lIns="0" tIns="0" rIns="0" bIns="0" rtlCol="0">
                <a:spAutoFit/>
              </a:bodyPr>
              <a:lstStyle/>
              <a:p>
                <a:pPr algn="ctr"/>
                <a:r>
                  <a:rPr lang="en-US" sz="700" dirty="0"/>
                  <a:t>AR4</a:t>
                </a:r>
                <a:endParaRPr lang="en-US" dirty="0"/>
              </a:p>
            </p:txBody>
          </p:sp>
        </p:grpSp>
        <p:grpSp>
          <p:nvGrpSpPr>
            <p:cNvPr id="222" name="Group 221"/>
            <p:cNvGrpSpPr/>
            <p:nvPr/>
          </p:nvGrpSpPr>
          <p:grpSpPr>
            <a:xfrm>
              <a:off x="6298743" y="3923739"/>
              <a:ext cx="171894" cy="1124712"/>
              <a:chOff x="7472893" y="3509420"/>
              <a:chExt cx="171894" cy="1124712"/>
            </a:xfrm>
          </p:grpSpPr>
          <p:sp>
            <p:nvSpPr>
              <p:cNvPr id="223" name="Rectangle 222"/>
              <p:cNvSpPr/>
              <p:nvPr/>
            </p:nvSpPr>
            <p:spPr>
              <a:xfrm>
                <a:off x="7635643" y="3509420"/>
                <a:ext cx="9144" cy="1124712"/>
              </a:xfrm>
              <a:prstGeom prst="rect">
                <a:avLst/>
              </a:prstGeom>
              <a:noFill/>
              <a:ln w="31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224" name="TextBox 223"/>
              <p:cNvSpPr txBox="1"/>
              <p:nvPr/>
            </p:nvSpPr>
            <p:spPr>
              <a:xfrm>
                <a:off x="7472893" y="3515728"/>
                <a:ext cx="157259" cy="107722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lIns="0" tIns="0" rIns="0" bIns="0" rtlCol="0">
                <a:spAutoFit/>
              </a:bodyPr>
              <a:lstStyle/>
              <a:p>
                <a:pPr algn="ctr"/>
                <a:r>
                  <a:rPr lang="en-US" sz="700" dirty="0"/>
                  <a:t>AR2</a:t>
                </a:r>
                <a:endParaRPr lang="en-US" dirty="0"/>
              </a:p>
            </p:txBody>
          </p:sp>
        </p:grpSp>
        <p:grpSp>
          <p:nvGrpSpPr>
            <p:cNvPr id="225" name="Group 224"/>
            <p:cNvGrpSpPr/>
            <p:nvPr/>
          </p:nvGrpSpPr>
          <p:grpSpPr>
            <a:xfrm>
              <a:off x="6786869" y="3922734"/>
              <a:ext cx="171894" cy="1124712"/>
              <a:chOff x="7472893" y="3509420"/>
              <a:chExt cx="171894" cy="1124712"/>
            </a:xfrm>
          </p:grpSpPr>
          <p:sp>
            <p:nvSpPr>
              <p:cNvPr id="226" name="Rectangle 225"/>
              <p:cNvSpPr/>
              <p:nvPr/>
            </p:nvSpPr>
            <p:spPr>
              <a:xfrm>
                <a:off x="7635643" y="3509420"/>
                <a:ext cx="9144" cy="1124712"/>
              </a:xfrm>
              <a:prstGeom prst="rect">
                <a:avLst/>
              </a:prstGeom>
              <a:noFill/>
              <a:ln w="31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227" name="TextBox 226"/>
              <p:cNvSpPr txBox="1"/>
              <p:nvPr/>
            </p:nvSpPr>
            <p:spPr>
              <a:xfrm>
                <a:off x="7472893" y="3515728"/>
                <a:ext cx="157259" cy="107722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lIns="0" tIns="0" rIns="0" bIns="0" rtlCol="0">
                <a:spAutoFit/>
              </a:bodyPr>
              <a:lstStyle/>
              <a:p>
                <a:pPr algn="ctr"/>
                <a:r>
                  <a:rPr lang="en-US" sz="700" dirty="0"/>
                  <a:t>AR3</a:t>
                </a:r>
                <a:endParaRPr lang="en-US" dirty="0"/>
              </a:p>
            </p:txBody>
          </p:sp>
        </p:grpSp>
        <p:grpSp>
          <p:nvGrpSpPr>
            <p:cNvPr id="228" name="Group 227"/>
            <p:cNvGrpSpPr/>
            <p:nvPr/>
          </p:nvGrpSpPr>
          <p:grpSpPr>
            <a:xfrm>
              <a:off x="5701437" y="3923739"/>
              <a:ext cx="171894" cy="1124712"/>
              <a:chOff x="7472893" y="3509420"/>
              <a:chExt cx="171894" cy="1124712"/>
            </a:xfrm>
          </p:grpSpPr>
          <p:sp>
            <p:nvSpPr>
              <p:cNvPr id="229" name="Rectangle 228"/>
              <p:cNvSpPr/>
              <p:nvPr/>
            </p:nvSpPr>
            <p:spPr>
              <a:xfrm>
                <a:off x="7635643" y="3509420"/>
                <a:ext cx="9144" cy="1124712"/>
              </a:xfrm>
              <a:prstGeom prst="rect">
                <a:avLst/>
              </a:prstGeom>
              <a:noFill/>
              <a:ln w="31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230" name="TextBox 229"/>
              <p:cNvSpPr txBox="1"/>
              <p:nvPr/>
            </p:nvSpPr>
            <p:spPr>
              <a:xfrm>
                <a:off x="7472893" y="3515728"/>
                <a:ext cx="157259" cy="107722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lIns="0" tIns="0" rIns="0" bIns="0" rtlCol="0">
                <a:spAutoFit/>
              </a:bodyPr>
              <a:lstStyle/>
              <a:p>
                <a:pPr algn="ctr"/>
                <a:r>
                  <a:rPr lang="en-US" sz="700" dirty="0"/>
                  <a:t>AR1</a:t>
                </a:r>
                <a:endParaRPr lang="en-US" dirty="0"/>
              </a:p>
            </p:txBody>
          </p:sp>
        </p:grpSp>
        <p:grpSp>
          <p:nvGrpSpPr>
            <p:cNvPr id="231" name="Group 230"/>
            <p:cNvGrpSpPr/>
            <p:nvPr/>
          </p:nvGrpSpPr>
          <p:grpSpPr>
            <a:xfrm>
              <a:off x="8082431" y="1759709"/>
              <a:ext cx="178553" cy="594360"/>
              <a:chOff x="7466234" y="3509420"/>
              <a:chExt cx="178553" cy="612648"/>
            </a:xfrm>
          </p:grpSpPr>
          <p:sp>
            <p:nvSpPr>
              <p:cNvPr id="232" name="Rectangle 231"/>
              <p:cNvSpPr/>
              <p:nvPr/>
            </p:nvSpPr>
            <p:spPr>
              <a:xfrm>
                <a:off x="7635643" y="3509420"/>
                <a:ext cx="9144" cy="612648"/>
              </a:xfrm>
              <a:prstGeom prst="rect">
                <a:avLst/>
              </a:prstGeom>
              <a:noFill/>
              <a:ln w="31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233" name="TextBox 232"/>
              <p:cNvSpPr txBox="1"/>
              <p:nvPr/>
            </p:nvSpPr>
            <p:spPr>
              <a:xfrm>
                <a:off x="7466234" y="3514105"/>
                <a:ext cx="163918" cy="111037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lIns="0" tIns="0" rIns="0" bIns="0" rtlCol="0">
                <a:spAutoFit/>
              </a:bodyPr>
              <a:lstStyle/>
              <a:p>
                <a:pPr algn="ctr"/>
                <a:r>
                  <a:rPr lang="en-US" sz="700" dirty="0"/>
                  <a:t>A5</a:t>
                </a:r>
                <a:endParaRPr lang="en-US" dirty="0"/>
              </a:p>
            </p:txBody>
          </p:sp>
        </p:grpSp>
        <p:grpSp>
          <p:nvGrpSpPr>
            <p:cNvPr id="234" name="Group 233"/>
            <p:cNvGrpSpPr/>
            <p:nvPr/>
          </p:nvGrpSpPr>
          <p:grpSpPr>
            <a:xfrm>
              <a:off x="6580020" y="1763519"/>
              <a:ext cx="178553" cy="594360"/>
              <a:chOff x="7466234" y="3509420"/>
              <a:chExt cx="178553" cy="612648"/>
            </a:xfrm>
          </p:grpSpPr>
          <p:sp>
            <p:nvSpPr>
              <p:cNvPr id="235" name="Rectangle 234"/>
              <p:cNvSpPr/>
              <p:nvPr/>
            </p:nvSpPr>
            <p:spPr>
              <a:xfrm>
                <a:off x="7635643" y="3509420"/>
                <a:ext cx="9144" cy="612648"/>
              </a:xfrm>
              <a:prstGeom prst="rect">
                <a:avLst/>
              </a:prstGeom>
              <a:noFill/>
              <a:ln w="31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236" name="TextBox 235"/>
              <p:cNvSpPr txBox="1"/>
              <p:nvPr/>
            </p:nvSpPr>
            <p:spPr>
              <a:xfrm>
                <a:off x="7466234" y="3514105"/>
                <a:ext cx="163918" cy="111037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lIns="0" tIns="0" rIns="0" bIns="0" rtlCol="0">
                <a:spAutoFit/>
              </a:bodyPr>
              <a:lstStyle/>
              <a:p>
                <a:pPr algn="ctr"/>
                <a:r>
                  <a:rPr lang="en-US" sz="700" dirty="0"/>
                  <a:t>A4</a:t>
                </a:r>
                <a:endParaRPr lang="en-US" dirty="0"/>
              </a:p>
            </p:txBody>
          </p:sp>
        </p:grpSp>
        <p:grpSp>
          <p:nvGrpSpPr>
            <p:cNvPr id="237" name="Group 236"/>
            <p:cNvGrpSpPr/>
            <p:nvPr/>
          </p:nvGrpSpPr>
          <p:grpSpPr>
            <a:xfrm>
              <a:off x="6371180" y="1761769"/>
              <a:ext cx="178553" cy="594360"/>
              <a:chOff x="7466234" y="3509420"/>
              <a:chExt cx="178553" cy="612648"/>
            </a:xfrm>
          </p:grpSpPr>
          <p:sp>
            <p:nvSpPr>
              <p:cNvPr id="238" name="Rectangle 237"/>
              <p:cNvSpPr/>
              <p:nvPr/>
            </p:nvSpPr>
            <p:spPr>
              <a:xfrm>
                <a:off x="7635643" y="3509420"/>
                <a:ext cx="9144" cy="612648"/>
              </a:xfrm>
              <a:prstGeom prst="rect">
                <a:avLst/>
              </a:prstGeom>
              <a:noFill/>
              <a:ln w="31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239" name="TextBox 238"/>
              <p:cNvSpPr txBox="1"/>
              <p:nvPr/>
            </p:nvSpPr>
            <p:spPr>
              <a:xfrm>
                <a:off x="7466234" y="3514105"/>
                <a:ext cx="163918" cy="111037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lIns="0" tIns="0" rIns="0" bIns="0" rtlCol="0">
                <a:spAutoFit/>
              </a:bodyPr>
              <a:lstStyle/>
              <a:p>
                <a:pPr algn="ctr"/>
                <a:r>
                  <a:rPr lang="en-US" sz="700" dirty="0"/>
                  <a:t>A3</a:t>
                </a:r>
                <a:endParaRPr lang="en-US" dirty="0"/>
              </a:p>
            </p:txBody>
          </p:sp>
        </p:grpSp>
        <p:grpSp>
          <p:nvGrpSpPr>
            <p:cNvPr id="240" name="Group 239"/>
            <p:cNvGrpSpPr/>
            <p:nvPr/>
          </p:nvGrpSpPr>
          <p:grpSpPr>
            <a:xfrm>
              <a:off x="5213048" y="1762129"/>
              <a:ext cx="178553" cy="594360"/>
              <a:chOff x="7466234" y="3509420"/>
              <a:chExt cx="178553" cy="612648"/>
            </a:xfrm>
          </p:grpSpPr>
          <p:sp>
            <p:nvSpPr>
              <p:cNvPr id="241" name="Rectangle 240"/>
              <p:cNvSpPr/>
              <p:nvPr/>
            </p:nvSpPr>
            <p:spPr>
              <a:xfrm>
                <a:off x="7635643" y="3509420"/>
                <a:ext cx="9144" cy="612648"/>
              </a:xfrm>
              <a:prstGeom prst="rect">
                <a:avLst/>
              </a:prstGeom>
              <a:noFill/>
              <a:ln w="31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242" name="TextBox 241"/>
              <p:cNvSpPr txBox="1"/>
              <p:nvPr/>
            </p:nvSpPr>
            <p:spPr>
              <a:xfrm>
                <a:off x="7466234" y="3514105"/>
                <a:ext cx="163918" cy="111037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lIns="0" tIns="0" rIns="0" bIns="0" rtlCol="0">
                <a:spAutoFit/>
              </a:bodyPr>
              <a:lstStyle/>
              <a:p>
                <a:pPr algn="ctr"/>
                <a:r>
                  <a:rPr lang="en-US" sz="700" dirty="0"/>
                  <a:t>A2</a:t>
                </a:r>
                <a:endParaRPr lang="en-US" dirty="0"/>
              </a:p>
            </p:txBody>
          </p:sp>
        </p:grpSp>
        <p:grpSp>
          <p:nvGrpSpPr>
            <p:cNvPr id="243" name="Group 242"/>
            <p:cNvGrpSpPr/>
            <p:nvPr/>
          </p:nvGrpSpPr>
          <p:grpSpPr>
            <a:xfrm>
              <a:off x="4075428" y="1759535"/>
              <a:ext cx="178553" cy="594360"/>
              <a:chOff x="7466234" y="3509420"/>
              <a:chExt cx="178553" cy="612648"/>
            </a:xfrm>
          </p:grpSpPr>
          <p:sp>
            <p:nvSpPr>
              <p:cNvPr id="244" name="Rectangle 243"/>
              <p:cNvSpPr/>
              <p:nvPr/>
            </p:nvSpPr>
            <p:spPr>
              <a:xfrm>
                <a:off x="7635643" y="3509420"/>
                <a:ext cx="9144" cy="612648"/>
              </a:xfrm>
              <a:prstGeom prst="rect">
                <a:avLst/>
              </a:prstGeom>
              <a:noFill/>
              <a:ln w="31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245" name="TextBox 244"/>
              <p:cNvSpPr txBox="1"/>
              <p:nvPr/>
            </p:nvSpPr>
            <p:spPr>
              <a:xfrm>
                <a:off x="7466234" y="3514105"/>
                <a:ext cx="163918" cy="111037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lIns="0" tIns="0" rIns="0" bIns="0" rtlCol="0">
                <a:spAutoFit/>
              </a:bodyPr>
              <a:lstStyle/>
              <a:p>
                <a:pPr algn="ctr"/>
                <a:r>
                  <a:rPr lang="en-US" sz="700" dirty="0"/>
                  <a:t>A1</a:t>
                </a:r>
                <a:endParaRPr lang="en-US" dirty="0"/>
              </a:p>
            </p:txBody>
          </p:sp>
        </p:grpSp>
        <p:grpSp>
          <p:nvGrpSpPr>
            <p:cNvPr id="246" name="Group 245"/>
            <p:cNvGrpSpPr/>
            <p:nvPr/>
          </p:nvGrpSpPr>
          <p:grpSpPr>
            <a:xfrm>
              <a:off x="4126072" y="843668"/>
              <a:ext cx="216981" cy="886968"/>
              <a:chOff x="7427806" y="3509420"/>
              <a:chExt cx="216981" cy="612648"/>
            </a:xfrm>
          </p:grpSpPr>
          <p:sp>
            <p:nvSpPr>
              <p:cNvPr id="247" name="Rectangle 246"/>
              <p:cNvSpPr/>
              <p:nvPr/>
            </p:nvSpPr>
            <p:spPr>
              <a:xfrm>
                <a:off x="7635643" y="3509420"/>
                <a:ext cx="9144" cy="612648"/>
              </a:xfrm>
              <a:prstGeom prst="rect">
                <a:avLst/>
              </a:prstGeom>
              <a:noFill/>
              <a:ln w="31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248" name="TextBox 247"/>
              <p:cNvSpPr txBox="1"/>
              <p:nvPr/>
            </p:nvSpPr>
            <p:spPr>
              <a:xfrm>
                <a:off x="7427806" y="3514105"/>
                <a:ext cx="202346" cy="74406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lIns="0" tIns="0" rIns="0" bIns="0" rtlCol="0">
                <a:spAutoFit/>
              </a:bodyPr>
              <a:lstStyle/>
              <a:p>
                <a:pPr algn="ctr"/>
                <a:r>
                  <a:rPr lang="en-US" sz="700" dirty="0"/>
                  <a:t>B-C1</a:t>
                </a:r>
                <a:endParaRPr lang="en-US" dirty="0"/>
              </a:p>
            </p:txBody>
          </p:sp>
        </p:grpSp>
        <p:grpSp>
          <p:nvGrpSpPr>
            <p:cNvPr id="249" name="Group 248"/>
            <p:cNvGrpSpPr/>
            <p:nvPr/>
          </p:nvGrpSpPr>
          <p:grpSpPr>
            <a:xfrm>
              <a:off x="4502707" y="843690"/>
              <a:ext cx="227347" cy="886968"/>
              <a:chOff x="7635643" y="3509420"/>
              <a:chExt cx="227347" cy="612648"/>
            </a:xfrm>
          </p:grpSpPr>
          <p:sp>
            <p:nvSpPr>
              <p:cNvPr id="250" name="Rectangle 249"/>
              <p:cNvSpPr/>
              <p:nvPr/>
            </p:nvSpPr>
            <p:spPr>
              <a:xfrm>
                <a:off x="7635643" y="3509420"/>
                <a:ext cx="9144" cy="612648"/>
              </a:xfrm>
              <a:prstGeom prst="rect">
                <a:avLst/>
              </a:prstGeom>
              <a:noFill/>
              <a:ln w="31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251" name="TextBox 250"/>
              <p:cNvSpPr txBox="1"/>
              <p:nvPr/>
            </p:nvSpPr>
            <p:spPr>
              <a:xfrm>
                <a:off x="7660644" y="3514090"/>
                <a:ext cx="202346" cy="74406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lIns="0" tIns="0" rIns="0" bIns="0" rtlCol="0">
                <a:spAutoFit/>
              </a:bodyPr>
              <a:lstStyle/>
              <a:p>
                <a:pPr algn="ctr"/>
                <a:r>
                  <a:rPr lang="en-US" sz="700" dirty="0"/>
                  <a:t>B-C2</a:t>
                </a:r>
                <a:endParaRPr lang="en-US" dirty="0"/>
              </a:p>
            </p:txBody>
          </p:sp>
        </p:grpSp>
        <p:grpSp>
          <p:nvGrpSpPr>
            <p:cNvPr id="252" name="Group 251"/>
            <p:cNvGrpSpPr/>
            <p:nvPr/>
          </p:nvGrpSpPr>
          <p:grpSpPr>
            <a:xfrm>
              <a:off x="4805425" y="851310"/>
              <a:ext cx="227347" cy="886968"/>
              <a:chOff x="7635643" y="3509420"/>
              <a:chExt cx="227347" cy="612648"/>
            </a:xfrm>
          </p:grpSpPr>
          <p:sp>
            <p:nvSpPr>
              <p:cNvPr id="253" name="Rectangle 252"/>
              <p:cNvSpPr/>
              <p:nvPr/>
            </p:nvSpPr>
            <p:spPr>
              <a:xfrm>
                <a:off x="7635643" y="3509420"/>
                <a:ext cx="9144" cy="612648"/>
              </a:xfrm>
              <a:prstGeom prst="rect">
                <a:avLst/>
              </a:prstGeom>
              <a:noFill/>
              <a:ln w="31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254" name="TextBox 253"/>
              <p:cNvSpPr txBox="1"/>
              <p:nvPr/>
            </p:nvSpPr>
            <p:spPr>
              <a:xfrm>
                <a:off x="7660644" y="3514090"/>
                <a:ext cx="202346" cy="74406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lIns="0" tIns="0" rIns="0" bIns="0" rtlCol="0">
                <a:spAutoFit/>
              </a:bodyPr>
              <a:lstStyle/>
              <a:p>
                <a:pPr algn="ctr"/>
                <a:r>
                  <a:rPr lang="en-US" sz="700" dirty="0"/>
                  <a:t>B-C3</a:t>
                </a:r>
                <a:endParaRPr lang="en-US" dirty="0"/>
              </a:p>
            </p:txBody>
          </p:sp>
        </p:grpSp>
        <p:grpSp>
          <p:nvGrpSpPr>
            <p:cNvPr id="255" name="Group 254"/>
            <p:cNvGrpSpPr/>
            <p:nvPr/>
          </p:nvGrpSpPr>
          <p:grpSpPr>
            <a:xfrm>
              <a:off x="5773228" y="847670"/>
              <a:ext cx="227347" cy="886968"/>
              <a:chOff x="7635643" y="3509420"/>
              <a:chExt cx="227347" cy="612648"/>
            </a:xfrm>
          </p:grpSpPr>
          <p:sp>
            <p:nvSpPr>
              <p:cNvPr id="256" name="Rectangle 255"/>
              <p:cNvSpPr/>
              <p:nvPr/>
            </p:nvSpPr>
            <p:spPr>
              <a:xfrm>
                <a:off x="7635643" y="3509420"/>
                <a:ext cx="9144" cy="612648"/>
              </a:xfrm>
              <a:prstGeom prst="rect">
                <a:avLst/>
              </a:prstGeom>
              <a:noFill/>
              <a:ln w="31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257" name="TextBox 256"/>
              <p:cNvSpPr txBox="1"/>
              <p:nvPr/>
            </p:nvSpPr>
            <p:spPr>
              <a:xfrm>
                <a:off x="7660644" y="3514090"/>
                <a:ext cx="202346" cy="74406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lIns="0" tIns="0" rIns="0" bIns="0" rtlCol="0">
                <a:spAutoFit/>
              </a:bodyPr>
              <a:lstStyle/>
              <a:p>
                <a:pPr algn="ctr"/>
                <a:r>
                  <a:rPr lang="en-US" sz="700" dirty="0"/>
                  <a:t>B-C4</a:t>
                </a:r>
                <a:endParaRPr lang="en-US" dirty="0"/>
              </a:p>
            </p:txBody>
          </p:sp>
        </p:grpSp>
        <p:grpSp>
          <p:nvGrpSpPr>
            <p:cNvPr id="258" name="Group 257"/>
            <p:cNvGrpSpPr/>
            <p:nvPr/>
          </p:nvGrpSpPr>
          <p:grpSpPr>
            <a:xfrm>
              <a:off x="6868519" y="844839"/>
              <a:ext cx="227347" cy="886968"/>
              <a:chOff x="7635643" y="3509420"/>
              <a:chExt cx="227347" cy="612648"/>
            </a:xfrm>
          </p:grpSpPr>
          <p:sp>
            <p:nvSpPr>
              <p:cNvPr id="259" name="Rectangle 258"/>
              <p:cNvSpPr/>
              <p:nvPr/>
            </p:nvSpPr>
            <p:spPr>
              <a:xfrm>
                <a:off x="7635643" y="3509420"/>
                <a:ext cx="9144" cy="612648"/>
              </a:xfrm>
              <a:prstGeom prst="rect">
                <a:avLst/>
              </a:prstGeom>
              <a:noFill/>
              <a:ln w="31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260" name="TextBox 259"/>
              <p:cNvSpPr txBox="1"/>
              <p:nvPr/>
            </p:nvSpPr>
            <p:spPr>
              <a:xfrm>
                <a:off x="7660644" y="3514090"/>
                <a:ext cx="202346" cy="74406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lIns="0" tIns="0" rIns="0" bIns="0" rtlCol="0">
                <a:spAutoFit/>
              </a:bodyPr>
              <a:lstStyle/>
              <a:p>
                <a:pPr algn="ctr"/>
                <a:r>
                  <a:rPr lang="en-US" sz="700" dirty="0"/>
                  <a:t>B-C5</a:t>
                </a:r>
                <a:endParaRPr lang="en-US" dirty="0"/>
              </a:p>
            </p:txBody>
          </p:sp>
        </p:grpSp>
        <p:grpSp>
          <p:nvGrpSpPr>
            <p:cNvPr id="261" name="Group 260"/>
            <p:cNvGrpSpPr/>
            <p:nvPr/>
          </p:nvGrpSpPr>
          <p:grpSpPr>
            <a:xfrm>
              <a:off x="7770466" y="847670"/>
              <a:ext cx="227347" cy="886968"/>
              <a:chOff x="7635643" y="3509420"/>
              <a:chExt cx="227347" cy="612648"/>
            </a:xfrm>
          </p:grpSpPr>
          <p:sp>
            <p:nvSpPr>
              <p:cNvPr id="262" name="Rectangle 261"/>
              <p:cNvSpPr/>
              <p:nvPr/>
            </p:nvSpPr>
            <p:spPr>
              <a:xfrm>
                <a:off x="7635643" y="3509420"/>
                <a:ext cx="9144" cy="612648"/>
              </a:xfrm>
              <a:prstGeom prst="rect">
                <a:avLst/>
              </a:prstGeom>
              <a:noFill/>
              <a:ln w="31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263" name="TextBox 262"/>
              <p:cNvSpPr txBox="1"/>
              <p:nvPr/>
            </p:nvSpPr>
            <p:spPr>
              <a:xfrm>
                <a:off x="7660644" y="3514090"/>
                <a:ext cx="202346" cy="74406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lIns="0" tIns="0" rIns="0" bIns="0" rtlCol="0">
                <a:spAutoFit/>
              </a:bodyPr>
              <a:lstStyle/>
              <a:p>
                <a:pPr algn="ctr"/>
                <a:r>
                  <a:rPr lang="en-US" sz="700" dirty="0"/>
                  <a:t>B-C6</a:t>
                </a:r>
                <a:endParaRPr lang="en-US" dirty="0"/>
              </a:p>
            </p:txBody>
          </p:sp>
        </p:grpSp>
        <p:grpSp>
          <p:nvGrpSpPr>
            <p:cNvPr id="264" name="Group 263"/>
            <p:cNvGrpSpPr/>
            <p:nvPr/>
          </p:nvGrpSpPr>
          <p:grpSpPr>
            <a:xfrm>
              <a:off x="7875304" y="847224"/>
              <a:ext cx="216271" cy="886968"/>
              <a:chOff x="7428516" y="3509420"/>
              <a:chExt cx="216271" cy="612648"/>
            </a:xfrm>
          </p:grpSpPr>
          <p:sp>
            <p:nvSpPr>
              <p:cNvPr id="265" name="Rectangle 264"/>
              <p:cNvSpPr/>
              <p:nvPr/>
            </p:nvSpPr>
            <p:spPr>
              <a:xfrm>
                <a:off x="7635643" y="3509420"/>
                <a:ext cx="9144" cy="612648"/>
              </a:xfrm>
              <a:prstGeom prst="rect">
                <a:avLst/>
              </a:prstGeom>
              <a:noFill/>
              <a:ln w="31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266" name="TextBox 265"/>
              <p:cNvSpPr txBox="1"/>
              <p:nvPr/>
            </p:nvSpPr>
            <p:spPr>
              <a:xfrm>
                <a:off x="7428516" y="3607893"/>
                <a:ext cx="202346" cy="74406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lIns="0" tIns="0" rIns="0" bIns="0" rtlCol="0">
                <a:spAutoFit/>
              </a:bodyPr>
              <a:lstStyle/>
              <a:p>
                <a:pPr algn="ctr"/>
                <a:r>
                  <a:rPr lang="en-US" sz="700" dirty="0"/>
                  <a:t>B-C7</a:t>
                </a:r>
                <a:endParaRPr lang="en-US" dirty="0"/>
              </a:p>
            </p:txBody>
          </p:sp>
        </p:grpSp>
        <p:sp>
          <p:nvSpPr>
            <p:cNvPr id="268" name="Rectangle 267"/>
            <p:cNvSpPr/>
            <p:nvPr/>
          </p:nvSpPr>
          <p:spPr>
            <a:xfrm>
              <a:off x="8173345" y="846269"/>
              <a:ext cx="9144" cy="886968"/>
            </a:xfrm>
            <a:prstGeom prst="rect">
              <a:avLst/>
            </a:prstGeom>
            <a:noFill/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grpSp>
          <p:nvGrpSpPr>
            <p:cNvPr id="270" name="Group 269"/>
            <p:cNvGrpSpPr/>
            <p:nvPr/>
          </p:nvGrpSpPr>
          <p:grpSpPr>
            <a:xfrm>
              <a:off x="8216815" y="846806"/>
              <a:ext cx="235557" cy="886968"/>
              <a:chOff x="7635643" y="3509420"/>
              <a:chExt cx="235557" cy="612648"/>
            </a:xfrm>
          </p:grpSpPr>
          <p:sp>
            <p:nvSpPr>
              <p:cNvPr id="271" name="Rectangle 270"/>
              <p:cNvSpPr/>
              <p:nvPr/>
            </p:nvSpPr>
            <p:spPr>
              <a:xfrm>
                <a:off x="7635643" y="3509420"/>
                <a:ext cx="9144" cy="612648"/>
              </a:xfrm>
              <a:prstGeom prst="rect">
                <a:avLst/>
              </a:prstGeom>
              <a:noFill/>
              <a:ln w="31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272" name="TextBox 271"/>
              <p:cNvSpPr txBox="1"/>
              <p:nvPr/>
            </p:nvSpPr>
            <p:spPr>
              <a:xfrm>
                <a:off x="7668854" y="3717349"/>
                <a:ext cx="202346" cy="74406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lIns="0" tIns="0" rIns="0" bIns="0" rtlCol="0">
                <a:spAutoFit/>
              </a:bodyPr>
              <a:lstStyle/>
              <a:p>
                <a:pPr algn="ctr"/>
                <a:r>
                  <a:rPr lang="en-US" sz="700" dirty="0"/>
                  <a:t>B-C9</a:t>
                </a:r>
                <a:endParaRPr lang="en-US" dirty="0"/>
              </a:p>
            </p:txBody>
          </p:sp>
        </p:grpSp>
        <p:sp>
          <p:nvSpPr>
            <p:cNvPr id="269" name="TextBox 268"/>
            <p:cNvSpPr txBox="1"/>
            <p:nvPr/>
          </p:nvSpPr>
          <p:spPr>
            <a:xfrm>
              <a:off x="8192050" y="998167"/>
              <a:ext cx="202346" cy="107722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en-US" sz="700" dirty="0"/>
                <a:t>B-C8</a:t>
              </a:r>
              <a:endParaRPr lang="en-US" dirty="0"/>
            </a:p>
          </p:txBody>
        </p:sp>
        <p:sp>
          <p:nvSpPr>
            <p:cNvPr id="274" name="TextBox 273"/>
            <p:cNvSpPr txBox="1"/>
            <p:nvPr/>
          </p:nvSpPr>
          <p:spPr>
            <a:xfrm>
              <a:off x="1594988" y="5686736"/>
              <a:ext cx="704416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00" i="1" dirty="0"/>
                <a:t>P.  angusta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257844580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3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66</TotalTime>
  <Words>762</Words>
  <Application>Microsoft Office PowerPoint</Application>
  <PresentationFormat>Widescreen</PresentationFormat>
  <Paragraphs>156</Paragraphs>
  <Slides>2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7" baseType="lpstr">
      <vt:lpstr>Arial</vt:lpstr>
      <vt:lpstr>Calibri</vt:lpstr>
      <vt:lpstr>Calibri Light</vt:lpstr>
      <vt:lpstr>Times New Roman</vt:lpstr>
      <vt:lpstr>Office Theme</vt:lpstr>
      <vt:lpstr>Variability in ITS1 and ITS2 sequences of historic (herbaria) and extant (fresh) Phalaris species (Graper, Noyszewski, Anderson, Smith) Supplementary Figure 3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Neil O Anderson</dc:creator>
  <cp:lastModifiedBy>Alli Graper</cp:lastModifiedBy>
  <cp:revision>8</cp:revision>
  <dcterms:created xsi:type="dcterms:W3CDTF">2020-12-01T21:43:30Z</dcterms:created>
  <dcterms:modified xsi:type="dcterms:W3CDTF">2021-05-24T04:24:50Z</dcterms:modified>
</cp:coreProperties>
</file>